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theme/themeOverride1.xml" ContentType="application/vnd.openxmlformats-officedocument.themeOverride+xml"/>
  <Override PartName="/ppt/charts/chart3.xml" ContentType="application/vnd.openxmlformats-officedocument.drawingml.chart+xml"/>
  <Override PartName="/ppt/theme/themeOverride2.xml" ContentType="application/vnd.openxmlformats-officedocument.themeOverride+xml"/>
  <Override PartName="/ppt/charts/chart4.xml" ContentType="application/vnd.openxmlformats-officedocument.drawingml.chart+xml"/>
  <Override PartName="/ppt/theme/themeOverride3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</p:sldIdLst>
  <p:sldSz cx="6858000" cy="9906000" type="A4"/>
  <p:notesSz cx="6735763" cy="9866313"/>
  <p:defaultTextStyle>
    <a:defPPr>
      <a:defRPr lang="ko-KR"/>
    </a:defPPr>
    <a:lvl1pPr algn="l" rtl="0" fontAlgn="base" latinLnBrk="1">
      <a:spcBef>
        <a:spcPct val="0"/>
      </a:spcBef>
      <a:spcAft>
        <a:spcPct val="0"/>
      </a:spcAft>
      <a:defRPr kumimoji="1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1pPr>
    <a:lvl2pPr marL="457200" algn="l" rtl="0" fontAlgn="base" latinLnBrk="1">
      <a:spcBef>
        <a:spcPct val="0"/>
      </a:spcBef>
      <a:spcAft>
        <a:spcPct val="0"/>
      </a:spcAft>
      <a:defRPr kumimoji="1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2pPr>
    <a:lvl3pPr marL="914400" algn="l" rtl="0" fontAlgn="base" latinLnBrk="1">
      <a:spcBef>
        <a:spcPct val="0"/>
      </a:spcBef>
      <a:spcAft>
        <a:spcPct val="0"/>
      </a:spcAft>
      <a:defRPr kumimoji="1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3pPr>
    <a:lvl4pPr marL="1371600" algn="l" rtl="0" fontAlgn="base" latinLnBrk="1">
      <a:spcBef>
        <a:spcPct val="0"/>
      </a:spcBef>
      <a:spcAft>
        <a:spcPct val="0"/>
      </a:spcAft>
      <a:defRPr kumimoji="1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4pPr>
    <a:lvl5pPr marL="1828800" algn="l" rtl="0" fontAlgn="base" latinLnBrk="1">
      <a:spcBef>
        <a:spcPct val="0"/>
      </a:spcBef>
      <a:spcAft>
        <a:spcPct val="0"/>
      </a:spcAft>
      <a:defRPr kumimoji="1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5pPr>
    <a:lvl6pPr marL="2286000" algn="l" defTabSz="914400" rtl="0" eaLnBrk="1" latinLnBrk="1" hangingPunct="1">
      <a:defRPr kumimoji="1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6pPr>
    <a:lvl7pPr marL="2743200" algn="l" defTabSz="914400" rtl="0" eaLnBrk="1" latinLnBrk="1" hangingPunct="1">
      <a:defRPr kumimoji="1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7pPr>
    <a:lvl8pPr marL="3200400" algn="l" defTabSz="914400" rtl="0" eaLnBrk="1" latinLnBrk="1" hangingPunct="1">
      <a:defRPr kumimoji="1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8pPr>
    <a:lvl9pPr marL="3657600" algn="l" defTabSz="914400" rtl="0" eaLnBrk="1" latinLnBrk="1" hangingPunct="1">
      <a:defRPr kumimoji="1" kern="1200">
        <a:solidFill>
          <a:schemeClr val="tx1"/>
        </a:solidFill>
        <a:latin typeface="굴림" panose="020B0600000101010101" pitchFamily="50" charset="-127"/>
        <a:ea typeface="굴림" panose="020B0600000101010101" pitchFamily="50" charset="-127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97" userDrawn="1">
          <p15:clr>
            <a:srgbClr val="A4A3A4"/>
          </p15:clr>
        </p15:guide>
        <p15:guide id="2" pos="95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밝은 스타일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295" autoAdjust="0"/>
    <p:restoredTop sz="94660"/>
  </p:normalViewPr>
  <p:slideViewPr>
    <p:cSldViewPr snapToGrid="0" showGuides="1">
      <p:cViewPr varScale="1">
        <p:scale>
          <a:sx n="79" d="100"/>
          <a:sy n="79" d="100"/>
        </p:scale>
        <p:origin x="3276" y="84"/>
      </p:cViewPr>
      <p:guideLst>
        <p:guide orient="horz" pos="3097"/>
        <p:guide pos="95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R.PARK\Documents\DaumCloud\Ruksana\Rusana%20data%2014715-1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DR.PARK\Documents\DaumCloud\Ruksana\Rusana%20data.xlsx" TargetMode="External"/><Relationship Id="rId1" Type="http://schemas.openxmlformats.org/officeDocument/2006/relationships/themeOverride" Target="../theme/themeOverride1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&#48149;&#45824;&#47161;\Documents\DaumCloud\Ruksana\Rusana%20data.xlsx" TargetMode="External"/><Relationship Id="rId1" Type="http://schemas.openxmlformats.org/officeDocument/2006/relationships/themeOverride" Target="../theme/themeOverride2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DR.PARK\Documents\DaumCloud\Ruksana\Rusana%20data.xlsx" TargetMode="External"/><Relationship Id="rId1" Type="http://schemas.openxmlformats.org/officeDocument/2006/relationships/themeOverride" Target="../theme/themeOverrid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Fig.6 B'!$L$1</c:f>
              <c:strCache>
                <c:ptCount val="1"/>
                <c:pt idx="0">
                  <c:v>Scramble shRNA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Fig.6 B'!$N$2:$N$101</c:f>
                <c:numCache>
                  <c:formatCode>General</c:formatCode>
                  <c:ptCount val="100"/>
                  <c:pt idx="0">
                    <c:v>0</c:v>
                  </c:pt>
                  <c:pt idx="1">
                    <c:v>0.17750001972222409</c:v>
                  </c:pt>
                  <c:pt idx="2">
                    <c:v>8.8779593197735096E-2</c:v>
                  </c:pt>
                  <c:pt idx="3">
                    <c:v>8.8720426524488971E-2</c:v>
                  </c:pt>
                  <c:pt idx="4">
                    <c:v>8.8720426524488971E-2</c:v>
                  </c:pt>
                  <c:pt idx="5">
                    <c:v>8.8720426524488971E-2</c:v>
                  </c:pt>
                  <c:pt idx="6">
                    <c:v>0.17750001972223828</c:v>
                  </c:pt>
                  <c:pt idx="7">
                    <c:v>8.8779593197735096E-2</c:v>
                  </c:pt>
                  <c:pt idx="8">
                    <c:v>0</c:v>
                  </c:pt>
                  <c:pt idx="9">
                    <c:v>0</c:v>
                  </c:pt>
                  <c:pt idx="10">
                    <c:v>3.6397073470240002</c:v>
                  </c:pt>
                  <c:pt idx="11">
                    <c:v>2.5222338466020062</c:v>
                  </c:pt>
                  <c:pt idx="12">
                    <c:v>1.5465367534299901</c:v>
                  </c:pt>
                  <c:pt idx="13">
                    <c:v>5.5490833691825117</c:v>
                  </c:pt>
                  <c:pt idx="14">
                    <c:v>21.641942694574254</c:v>
                  </c:pt>
                  <c:pt idx="15">
                    <c:v>1.0876114418765042</c:v>
                  </c:pt>
                  <c:pt idx="16">
                    <c:v>2.8939453461635196</c:v>
                  </c:pt>
                  <c:pt idx="17">
                    <c:v>39.638255508156611</c:v>
                  </c:pt>
                  <c:pt idx="18">
                    <c:v>24.706203587505001</c:v>
                  </c:pt>
                  <c:pt idx="19">
                    <c:v>42.59614244946755</c:v>
                  </c:pt>
                  <c:pt idx="20">
                    <c:v>25.561900411146496</c:v>
                  </c:pt>
                  <c:pt idx="21">
                    <c:v>37.138995457543601</c:v>
                  </c:pt>
                  <c:pt idx="22">
                    <c:v>42.277134835152424</c:v>
                  </c:pt>
                  <c:pt idx="23">
                    <c:v>1.985804141909</c:v>
                  </c:pt>
                  <c:pt idx="24">
                    <c:v>24.70851515510077</c:v>
                  </c:pt>
                  <c:pt idx="25">
                    <c:v>17.215343822389997</c:v>
                  </c:pt>
                  <c:pt idx="26">
                    <c:v>2.3389582800919868</c:v>
                  </c:pt>
                  <c:pt idx="27">
                    <c:v>17.623652791802016</c:v>
                  </c:pt>
                  <c:pt idx="28">
                    <c:v>29.361130140105018</c:v>
                  </c:pt>
                  <c:pt idx="29">
                    <c:v>35.564971245586811</c:v>
                  </c:pt>
                  <c:pt idx="30">
                    <c:v>1.9464752654889992</c:v>
                  </c:pt>
                  <c:pt idx="31">
                    <c:v>11.241756600719498</c:v>
                  </c:pt>
                  <c:pt idx="32">
                    <c:v>18.818837579057998</c:v>
                  </c:pt>
                  <c:pt idx="33">
                    <c:v>3.0574985949135112</c:v>
                  </c:pt>
                  <c:pt idx="34">
                    <c:v>27.624150234015502</c:v>
                  </c:pt>
                  <c:pt idx="35">
                    <c:v>14.104099168896994</c:v>
                  </c:pt>
                  <c:pt idx="36">
                    <c:v>17.537748520051508</c:v>
                  </c:pt>
                  <c:pt idx="37">
                    <c:v>4.9856572268840011</c:v>
                  </c:pt>
                  <c:pt idx="38">
                    <c:v>1.1707460395505223</c:v>
                  </c:pt>
                  <c:pt idx="39">
                    <c:v>1.0629490145680052</c:v>
                  </c:pt>
                  <c:pt idx="40">
                    <c:v>45.923080849326404</c:v>
                  </c:pt>
                  <c:pt idx="41">
                    <c:v>25.351924997475521</c:v>
                  </c:pt>
                  <c:pt idx="42">
                    <c:v>18.966502925191008</c:v>
                  </c:pt>
                  <c:pt idx="43">
                    <c:v>6.5090637949369921</c:v>
                  </c:pt>
                  <c:pt idx="44">
                    <c:v>7.1252425614489994</c:v>
                  </c:pt>
                  <c:pt idx="45">
                    <c:v>11.382069411029988</c:v>
                  </c:pt>
                  <c:pt idx="46">
                    <c:v>1.2577997362359952</c:v>
                  </c:pt>
                  <c:pt idx="47">
                    <c:v>15.233588636030504</c:v>
                  </c:pt>
                  <c:pt idx="48">
                    <c:v>34.812824641726507</c:v>
                  </c:pt>
                  <c:pt idx="49">
                    <c:v>18.099910619914994</c:v>
                  </c:pt>
                  <c:pt idx="50">
                    <c:v>1.3405144442704966</c:v>
                  </c:pt>
                  <c:pt idx="51">
                    <c:v>15.317500099682007</c:v>
                  </c:pt>
                  <c:pt idx="52">
                    <c:v>11.799634591960993</c:v>
                  </c:pt>
                  <c:pt idx="53">
                    <c:v>7.645361469204488</c:v>
                  </c:pt>
                  <c:pt idx="54">
                    <c:v>2.7368717530164872</c:v>
                  </c:pt>
                  <c:pt idx="55">
                    <c:v>18.524047669468985</c:v>
                  </c:pt>
                  <c:pt idx="56">
                    <c:v>1.5284156142365077</c:v>
                  </c:pt>
                  <c:pt idx="57">
                    <c:v>27.077732714926498</c:v>
                  </c:pt>
                  <c:pt idx="58">
                    <c:v>7.8132761969280011</c:v>
                  </c:pt>
                  <c:pt idx="59">
                    <c:v>15.272009370292494</c:v>
                  </c:pt>
                  <c:pt idx="60">
                    <c:v>27.232632441773006</c:v>
                  </c:pt>
                  <c:pt idx="61">
                    <c:v>2.5745445473565098</c:v>
                  </c:pt>
                  <c:pt idx="62">
                    <c:v>3.6997437005929896</c:v>
                  </c:pt>
                  <c:pt idx="63">
                    <c:v>35.151118344237574</c:v>
                  </c:pt>
                  <c:pt idx="64">
                    <c:v>3.5979884434395046</c:v>
                  </c:pt>
                  <c:pt idx="65">
                    <c:v>10.790640897197505</c:v>
                  </c:pt>
                  <c:pt idx="66">
                    <c:v>4.4418498114820011</c:v>
                  </c:pt>
                  <c:pt idx="67">
                    <c:v>3.045766839073508</c:v>
                  </c:pt>
                  <c:pt idx="68">
                    <c:v>8.0858284300794878</c:v>
                  </c:pt>
                  <c:pt idx="69">
                    <c:v>5.5086510822129924</c:v>
                  </c:pt>
                  <c:pt idx="70">
                    <c:v>0.8539504988465012</c:v>
                  </c:pt>
                  <c:pt idx="71">
                    <c:v>11.848722043938977</c:v>
                  </c:pt>
                  <c:pt idx="72">
                    <c:v>13.919672060595502</c:v>
                  </c:pt>
                  <c:pt idx="73">
                    <c:v>33.833959115561015</c:v>
                  </c:pt>
                  <c:pt idx="74">
                    <c:v>3.7359625577680049</c:v>
                  </c:pt>
                  <c:pt idx="75">
                    <c:v>2.0344525350595006</c:v>
                  </c:pt>
                  <c:pt idx="76">
                    <c:v>0.1054280636764986</c:v>
                  </c:pt>
                  <c:pt idx="77">
                    <c:v>2.7482353232620085</c:v>
                  </c:pt>
                  <c:pt idx="78">
                    <c:v>16.563936902161487</c:v>
                  </c:pt>
                  <c:pt idx="79">
                    <c:v>25.465458452049006</c:v>
                  </c:pt>
                  <c:pt idx="80">
                    <c:v>1.5336088335870102</c:v>
                  </c:pt>
                  <c:pt idx="81">
                    <c:v>3.4040167013924929</c:v>
                  </c:pt>
                  <c:pt idx="82">
                    <c:v>28.364812906294503</c:v>
                  </c:pt>
                  <c:pt idx="83">
                    <c:v>3.7193745970340046</c:v>
                  </c:pt>
                  <c:pt idx="84">
                    <c:v>4.2841588477599828</c:v>
                  </c:pt>
                  <c:pt idx="85">
                    <c:v>8.006994042809481</c:v>
                  </c:pt>
                  <c:pt idx="86">
                    <c:v>15.237700477792487</c:v>
                  </c:pt>
                  <c:pt idx="87">
                    <c:v>8.9062460799975156</c:v>
                  </c:pt>
                  <c:pt idx="88">
                    <c:v>20.631743687946511</c:v>
                  </c:pt>
                  <c:pt idx="89">
                    <c:v>14.279342046227526</c:v>
                  </c:pt>
                  <c:pt idx="90">
                    <c:v>15.825454252902489</c:v>
                  </c:pt>
                  <c:pt idx="91">
                    <c:v>5.210752514208508</c:v>
                  </c:pt>
                  <c:pt idx="92">
                    <c:v>1.4222572227764942</c:v>
                  </c:pt>
                  <c:pt idx="93">
                    <c:v>40.774999623392404</c:v>
                  </c:pt>
                  <c:pt idx="94">
                    <c:v>2.8071013660850213</c:v>
                  </c:pt>
                  <c:pt idx="95">
                    <c:v>16.472288175960017</c:v>
                  </c:pt>
                  <c:pt idx="96">
                    <c:v>3.1000499001994797</c:v>
                  </c:pt>
                  <c:pt idx="97">
                    <c:v>2.9667482767479783</c:v>
                  </c:pt>
                  <c:pt idx="98">
                    <c:v>22.154887574252001</c:v>
                  </c:pt>
                  <c:pt idx="99">
                    <c:v>13.35009159965</c:v>
                  </c:pt>
                </c:numCache>
              </c:numRef>
            </c:plus>
            <c:minus>
              <c:numRef>
                <c:f>'Fig.6 B'!$N$2:$N$101</c:f>
                <c:numCache>
                  <c:formatCode>General</c:formatCode>
                  <c:ptCount val="100"/>
                  <c:pt idx="0">
                    <c:v>0</c:v>
                  </c:pt>
                  <c:pt idx="1">
                    <c:v>0.17750001972222409</c:v>
                  </c:pt>
                  <c:pt idx="2">
                    <c:v>8.8779593197735096E-2</c:v>
                  </c:pt>
                  <c:pt idx="3">
                    <c:v>8.8720426524488971E-2</c:v>
                  </c:pt>
                  <c:pt idx="4">
                    <c:v>8.8720426524488971E-2</c:v>
                  </c:pt>
                  <c:pt idx="5">
                    <c:v>8.8720426524488971E-2</c:v>
                  </c:pt>
                  <c:pt idx="6">
                    <c:v>0.17750001972223828</c:v>
                  </c:pt>
                  <c:pt idx="7">
                    <c:v>8.8779593197735096E-2</c:v>
                  </c:pt>
                  <c:pt idx="8">
                    <c:v>0</c:v>
                  </c:pt>
                  <c:pt idx="9">
                    <c:v>0</c:v>
                  </c:pt>
                  <c:pt idx="10">
                    <c:v>3.6397073470240002</c:v>
                  </c:pt>
                  <c:pt idx="11">
                    <c:v>2.5222338466020062</c:v>
                  </c:pt>
                  <c:pt idx="12">
                    <c:v>1.5465367534299901</c:v>
                  </c:pt>
                  <c:pt idx="13">
                    <c:v>5.5490833691825117</c:v>
                  </c:pt>
                  <c:pt idx="14">
                    <c:v>21.641942694574254</c:v>
                  </c:pt>
                  <c:pt idx="15">
                    <c:v>1.0876114418765042</c:v>
                  </c:pt>
                  <c:pt idx="16">
                    <c:v>2.8939453461635196</c:v>
                  </c:pt>
                  <c:pt idx="17">
                    <c:v>39.638255508156611</c:v>
                  </c:pt>
                  <c:pt idx="18">
                    <c:v>24.706203587505001</c:v>
                  </c:pt>
                  <c:pt idx="19">
                    <c:v>42.59614244946755</c:v>
                  </c:pt>
                  <c:pt idx="20">
                    <c:v>25.561900411146496</c:v>
                  </c:pt>
                  <c:pt idx="21">
                    <c:v>37.138995457543601</c:v>
                  </c:pt>
                  <c:pt idx="22">
                    <c:v>42.277134835152424</c:v>
                  </c:pt>
                  <c:pt idx="23">
                    <c:v>1.985804141909</c:v>
                  </c:pt>
                  <c:pt idx="24">
                    <c:v>24.70851515510077</c:v>
                  </c:pt>
                  <c:pt idx="25">
                    <c:v>17.215343822389997</c:v>
                  </c:pt>
                  <c:pt idx="26">
                    <c:v>2.3389582800919868</c:v>
                  </c:pt>
                  <c:pt idx="27">
                    <c:v>17.623652791802016</c:v>
                  </c:pt>
                  <c:pt idx="28">
                    <c:v>29.361130140105018</c:v>
                  </c:pt>
                  <c:pt idx="29">
                    <c:v>35.564971245586811</c:v>
                  </c:pt>
                  <c:pt idx="30">
                    <c:v>1.9464752654889992</c:v>
                  </c:pt>
                  <c:pt idx="31">
                    <c:v>11.241756600719498</c:v>
                  </c:pt>
                  <c:pt idx="32">
                    <c:v>18.818837579057998</c:v>
                  </c:pt>
                  <c:pt idx="33">
                    <c:v>3.0574985949135112</c:v>
                  </c:pt>
                  <c:pt idx="34">
                    <c:v>27.624150234015502</c:v>
                  </c:pt>
                  <c:pt idx="35">
                    <c:v>14.104099168896994</c:v>
                  </c:pt>
                  <c:pt idx="36">
                    <c:v>17.537748520051508</c:v>
                  </c:pt>
                  <c:pt idx="37">
                    <c:v>4.9856572268840011</c:v>
                  </c:pt>
                  <c:pt idx="38">
                    <c:v>1.1707460395505223</c:v>
                  </c:pt>
                  <c:pt idx="39">
                    <c:v>1.0629490145680052</c:v>
                  </c:pt>
                  <c:pt idx="40">
                    <c:v>45.923080849326404</c:v>
                  </c:pt>
                  <c:pt idx="41">
                    <c:v>25.351924997475521</c:v>
                  </c:pt>
                  <c:pt idx="42">
                    <c:v>18.966502925191008</c:v>
                  </c:pt>
                  <c:pt idx="43">
                    <c:v>6.5090637949369921</c:v>
                  </c:pt>
                  <c:pt idx="44">
                    <c:v>7.1252425614489994</c:v>
                  </c:pt>
                  <c:pt idx="45">
                    <c:v>11.382069411029988</c:v>
                  </c:pt>
                  <c:pt idx="46">
                    <c:v>1.2577997362359952</c:v>
                  </c:pt>
                  <c:pt idx="47">
                    <c:v>15.233588636030504</c:v>
                  </c:pt>
                  <c:pt idx="48">
                    <c:v>34.812824641726507</c:v>
                  </c:pt>
                  <c:pt idx="49">
                    <c:v>18.099910619914994</c:v>
                  </c:pt>
                  <c:pt idx="50">
                    <c:v>1.3405144442704966</c:v>
                  </c:pt>
                  <c:pt idx="51">
                    <c:v>15.317500099682007</c:v>
                  </c:pt>
                  <c:pt idx="52">
                    <c:v>11.799634591960993</c:v>
                  </c:pt>
                  <c:pt idx="53">
                    <c:v>7.645361469204488</c:v>
                  </c:pt>
                  <c:pt idx="54">
                    <c:v>2.7368717530164872</c:v>
                  </c:pt>
                  <c:pt idx="55">
                    <c:v>18.524047669468985</c:v>
                  </c:pt>
                  <c:pt idx="56">
                    <c:v>1.5284156142365077</c:v>
                  </c:pt>
                  <c:pt idx="57">
                    <c:v>27.077732714926498</c:v>
                  </c:pt>
                  <c:pt idx="58">
                    <c:v>7.8132761969280011</c:v>
                  </c:pt>
                  <c:pt idx="59">
                    <c:v>15.272009370292494</c:v>
                  </c:pt>
                  <c:pt idx="60">
                    <c:v>27.232632441773006</c:v>
                  </c:pt>
                  <c:pt idx="61">
                    <c:v>2.5745445473565098</c:v>
                  </c:pt>
                  <c:pt idx="62">
                    <c:v>3.6997437005929896</c:v>
                  </c:pt>
                  <c:pt idx="63">
                    <c:v>35.151118344237574</c:v>
                  </c:pt>
                  <c:pt idx="64">
                    <c:v>3.5979884434395046</c:v>
                  </c:pt>
                  <c:pt idx="65">
                    <c:v>10.790640897197505</c:v>
                  </c:pt>
                  <c:pt idx="66">
                    <c:v>4.4418498114820011</c:v>
                  </c:pt>
                  <c:pt idx="67">
                    <c:v>3.045766839073508</c:v>
                  </c:pt>
                  <c:pt idx="68">
                    <c:v>8.0858284300794878</c:v>
                  </c:pt>
                  <c:pt idx="69">
                    <c:v>5.5086510822129924</c:v>
                  </c:pt>
                  <c:pt idx="70">
                    <c:v>0.8539504988465012</c:v>
                  </c:pt>
                  <c:pt idx="71">
                    <c:v>11.848722043938977</c:v>
                  </c:pt>
                  <c:pt idx="72">
                    <c:v>13.919672060595502</c:v>
                  </c:pt>
                  <c:pt idx="73">
                    <c:v>33.833959115561015</c:v>
                  </c:pt>
                  <c:pt idx="74">
                    <c:v>3.7359625577680049</c:v>
                  </c:pt>
                  <c:pt idx="75">
                    <c:v>2.0344525350595006</c:v>
                  </c:pt>
                  <c:pt idx="76">
                    <c:v>0.1054280636764986</c:v>
                  </c:pt>
                  <c:pt idx="77">
                    <c:v>2.7482353232620085</c:v>
                  </c:pt>
                  <c:pt idx="78">
                    <c:v>16.563936902161487</c:v>
                  </c:pt>
                  <c:pt idx="79">
                    <c:v>25.465458452049006</c:v>
                  </c:pt>
                  <c:pt idx="80">
                    <c:v>1.5336088335870102</c:v>
                  </c:pt>
                  <c:pt idx="81">
                    <c:v>3.4040167013924929</c:v>
                  </c:pt>
                  <c:pt idx="82">
                    <c:v>28.364812906294503</c:v>
                  </c:pt>
                  <c:pt idx="83">
                    <c:v>3.7193745970340046</c:v>
                  </c:pt>
                  <c:pt idx="84">
                    <c:v>4.2841588477599828</c:v>
                  </c:pt>
                  <c:pt idx="85">
                    <c:v>8.006994042809481</c:v>
                  </c:pt>
                  <c:pt idx="86">
                    <c:v>15.237700477792487</c:v>
                  </c:pt>
                  <c:pt idx="87">
                    <c:v>8.9062460799975156</c:v>
                  </c:pt>
                  <c:pt idx="88">
                    <c:v>20.631743687946511</c:v>
                  </c:pt>
                  <c:pt idx="89">
                    <c:v>14.279342046227526</c:v>
                  </c:pt>
                  <c:pt idx="90">
                    <c:v>15.825454252902489</c:v>
                  </c:pt>
                  <c:pt idx="91">
                    <c:v>5.210752514208508</c:v>
                  </c:pt>
                  <c:pt idx="92">
                    <c:v>1.4222572227764942</c:v>
                  </c:pt>
                  <c:pt idx="93">
                    <c:v>40.774999623392404</c:v>
                  </c:pt>
                  <c:pt idx="94">
                    <c:v>2.8071013660850213</c:v>
                  </c:pt>
                  <c:pt idx="95">
                    <c:v>16.472288175960017</c:v>
                  </c:pt>
                  <c:pt idx="96">
                    <c:v>3.1000499001994797</c:v>
                  </c:pt>
                  <c:pt idx="97">
                    <c:v>2.9667482767479783</c:v>
                  </c:pt>
                  <c:pt idx="98">
                    <c:v>22.154887574252001</c:v>
                  </c:pt>
                  <c:pt idx="99">
                    <c:v>13.3500915996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bg2">
                    <a:lumMod val="90000"/>
                  </a:schemeClr>
                </a:solidFill>
                <a:round/>
              </a:ln>
              <a:effectLst/>
            </c:spPr>
          </c:errBars>
          <c:cat>
            <c:numRef>
              <c:f>'Fig.6 B'!$K$2:$K$101</c:f>
              <c:numCache>
                <c:formatCode>General</c:formatCode>
                <c:ptCount val="100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5</c:v>
                </c:pt>
                <c:pt idx="6">
                  <c:v>18</c:v>
                </c:pt>
                <c:pt idx="7">
                  <c:v>21</c:v>
                </c:pt>
                <c:pt idx="8">
                  <c:v>24</c:v>
                </c:pt>
                <c:pt idx="9">
                  <c:v>27</c:v>
                </c:pt>
                <c:pt idx="10">
                  <c:v>30</c:v>
                </c:pt>
                <c:pt idx="11">
                  <c:v>33</c:v>
                </c:pt>
                <c:pt idx="12">
                  <c:v>36</c:v>
                </c:pt>
                <c:pt idx="13">
                  <c:v>39</c:v>
                </c:pt>
                <c:pt idx="14">
                  <c:v>42</c:v>
                </c:pt>
                <c:pt idx="15">
                  <c:v>45</c:v>
                </c:pt>
                <c:pt idx="16">
                  <c:v>48</c:v>
                </c:pt>
                <c:pt idx="17">
                  <c:v>51</c:v>
                </c:pt>
                <c:pt idx="18">
                  <c:v>54</c:v>
                </c:pt>
                <c:pt idx="19">
                  <c:v>57</c:v>
                </c:pt>
                <c:pt idx="20">
                  <c:v>60</c:v>
                </c:pt>
                <c:pt idx="21">
                  <c:v>63</c:v>
                </c:pt>
                <c:pt idx="22">
                  <c:v>66</c:v>
                </c:pt>
                <c:pt idx="23">
                  <c:v>69</c:v>
                </c:pt>
                <c:pt idx="24">
                  <c:v>72</c:v>
                </c:pt>
                <c:pt idx="25">
                  <c:v>75</c:v>
                </c:pt>
                <c:pt idx="26">
                  <c:v>78</c:v>
                </c:pt>
                <c:pt idx="27">
                  <c:v>81</c:v>
                </c:pt>
                <c:pt idx="28">
                  <c:v>84</c:v>
                </c:pt>
                <c:pt idx="29">
                  <c:v>87</c:v>
                </c:pt>
                <c:pt idx="30">
                  <c:v>90</c:v>
                </c:pt>
                <c:pt idx="31">
                  <c:v>93</c:v>
                </c:pt>
                <c:pt idx="32">
                  <c:v>96</c:v>
                </c:pt>
                <c:pt idx="33">
                  <c:v>99</c:v>
                </c:pt>
                <c:pt idx="34">
                  <c:v>102</c:v>
                </c:pt>
                <c:pt idx="35">
                  <c:v>105</c:v>
                </c:pt>
                <c:pt idx="36">
                  <c:v>108</c:v>
                </c:pt>
                <c:pt idx="37">
                  <c:v>111</c:v>
                </c:pt>
                <c:pt idx="38">
                  <c:v>114</c:v>
                </c:pt>
                <c:pt idx="39">
                  <c:v>117</c:v>
                </c:pt>
                <c:pt idx="40">
                  <c:v>120</c:v>
                </c:pt>
                <c:pt idx="41">
                  <c:v>123</c:v>
                </c:pt>
                <c:pt idx="42">
                  <c:v>126</c:v>
                </c:pt>
                <c:pt idx="43">
                  <c:v>129</c:v>
                </c:pt>
                <c:pt idx="44">
                  <c:v>132</c:v>
                </c:pt>
                <c:pt idx="45">
                  <c:v>135</c:v>
                </c:pt>
                <c:pt idx="46">
                  <c:v>138</c:v>
                </c:pt>
                <c:pt idx="47">
                  <c:v>141</c:v>
                </c:pt>
                <c:pt idx="48">
                  <c:v>144</c:v>
                </c:pt>
                <c:pt idx="49">
                  <c:v>147</c:v>
                </c:pt>
                <c:pt idx="50">
                  <c:v>150</c:v>
                </c:pt>
                <c:pt idx="51">
                  <c:v>153</c:v>
                </c:pt>
                <c:pt idx="52">
                  <c:v>156</c:v>
                </c:pt>
                <c:pt idx="53">
                  <c:v>159</c:v>
                </c:pt>
                <c:pt idx="54">
                  <c:v>162</c:v>
                </c:pt>
                <c:pt idx="55">
                  <c:v>165</c:v>
                </c:pt>
                <c:pt idx="56">
                  <c:v>168</c:v>
                </c:pt>
                <c:pt idx="57">
                  <c:v>171</c:v>
                </c:pt>
                <c:pt idx="58">
                  <c:v>174</c:v>
                </c:pt>
                <c:pt idx="59">
                  <c:v>177</c:v>
                </c:pt>
                <c:pt idx="60">
                  <c:v>180</c:v>
                </c:pt>
                <c:pt idx="61">
                  <c:v>183</c:v>
                </c:pt>
                <c:pt idx="62">
                  <c:v>186</c:v>
                </c:pt>
                <c:pt idx="63">
                  <c:v>189</c:v>
                </c:pt>
                <c:pt idx="64">
                  <c:v>192</c:v>
                </c:pt>
                <c:pt idx="65">
                  <c:v>195</c:v>
                </c:pt>
                <c:pt idx="66">
                  <c:v>198</c:v>
                </c:pt>
                <c:pt idx="67">
                  <c:v>201</c:v>
                </c:pt>
                <c:pt idx="68">
                  <c:v>204</c:v>
                </c:pt>
                <c:pt idx="69">
                  <c:v>207</c:v>
                </c:pt>
                <c:pt idx="70">
                  <c:v>210</c:v>
                </c:pt>
                <c:pt idx="71">
                  <c:v>213</c:v>
                </c:pt>
                <c:pt idx="72">
                  <c:v>216</c:v>
                </c:pt>
                <c:pt idx="73">
                  <c:v>219</c:v>
                </c:pt>
                <c:pt idx="74">
                  <c:v>222</c:v>
                </c:pt>
                <c:pt idx="75">
                  <c:v>225</c:v>
                </c:pt>
                <c:pt idx="76">
                  <c:v>228</c:v>
                </c:pt>
                <c:pt idx="77">
                  <c:v>231</c:v>
                </c:pt>
                <c:pt idx="78">
                  <c:v>234</c:v>
                </c:pt>
                <c:pt idx="79">
                  <c:v>237</c:v>
                </c:pt>
                <c:pt idx="80">
                  <c:v>240</c:v>
                </c:pt>
                <c:pt idx="81">
                  <c:v>243</c:v>
                </c:pt>
                <c:pt idx="82">
                  <c:v>246</c:v>
                </c:pt>
                <c:pt idx="83">
                  <c:v>249</c:v>
                </c:pt>
                <c:pt idx="84">
                  <c:v>252</c:v>
                </c:pt>
                <c:pt idx="85">
                  <c:v>255</c:v>
                </c:pt>
                <c:pt idx="86">
                  <c:v>258</c:v>
                </c:pt>
                <c:pt idx="87">
                  <c:v>261</c:v>
                </c:pt>
                <c:pt idx="88">
                  <c:v>264</c:v>
                </c:pt>
                <c:pt idx="89">
                  <c:v>267</c:v>
                </c:pt>
                <c:pt idx="90">
                  <c:v>270</c:v>
                </c:pt>
                <c:pt idx="91">
                  <c:v>273</c:v>
                </c:pt>
                <c:pt idx="92">
                  <c:v>276</c:v>
                </c:pt>
                <c:pt idx="93">
                  <c:v>279</c:v>
                </c:pt>
                <c:pt idx="94">
                  <c:v>282</c:v>
                </c:pt>
                <c:pt idx="95">
                  <c:v>285</c:v>
                </c:pt>
                <c:pt idx="96">
                  <c:v>288</c:v>
                </c:pt>
                <c:pt idx="97">
                  <c:v>291</c:v>
                </c:pt>
                <c:pt idx="98">
                  <c:v>294</c:v>
                </c:pt>
                <c:pt idx="99">
                  <c:v>297</c:v>
                </c:pt>
              </c:numCache>
            </c:numRef>
          </c:cat>
          <c:val>
            <c:numRef>
              <c:f>'Fig.6 B'!$L$2:$L$101</c:f>
              <c:numCache>
                <c:formatCode>General</c:formatCode>
                <c:ptCount val="100"/>
                <c:pt idx="0">
                  <c:v>82.5</c:v>
                </c:pt>
                <c:pt idx="1">
                  <c:v>82.500059166673253</c:v>
                </c:pt>
                <c:pt idx="2">
                  <c:v>82.588779593197728</c:v>
                </c:pt>
                <c:pt idx="3">
                  <c:v>82.411279573475511</c:v>
                </c:pt>
                <c:pt idx="4">
                  <c:v>82.411279573475511</c:v>
                </c:pt>
                <c:pt idx="5">
                  <c:v>82.411279573475511</c:v>
                </c:pt>
                <c:pt idx="6">
                  <c:v>82.500059166673225</c:v>
                </c:pt>
                <c:pt idx="7">
                  <c:v>82.588779593197728</c:v>
                </c:pt>
                <c:pt idx="8">
                  <c:v>82.5</c:v>
                </c:pt>
                <c:pt idx="9">
                  <c:v>82.5</c:v>
                </c:pt>
                <c:pt idx="10">
                  <c:v>256.42565213009999</c:v>
                </c:pt>
                <c:pt idx="11">
                  <c:v>289.69354858763791</c:v>
                </c:pt>
                <c:pt idx="12">
                  <c:v>274.09104713918703</c:v>
                </c:pt>
                <c:pt idx="13">
                  <c:v>263.93431146476553</c:v>
                </c:pt>
                <c:pt idx="14">
                  <c:v>329.10993700467384</c:v>
                </c:pt>
                <c:pt idx="15">
                  <c:v>339.48540149712551</c:v>
                </c:pt>
                <c:pt idx="16">
                  <c:v>324.65486159526847</c:v>
                </c:pt>
                <c:pt idx="17">
                  <c:v>327.87237456528749</c:v>
                </c:pt>
                <c:pt idx="18">
                  <c:v>323.83257498124698</c:v>
                </c:pt>
                <c:pt idx="19">
                  <c:v>322.77365724236648</c:v>
                </c:pt>
                <c:pt idx="20">
                  <c:v>305.3471904979445</c:v>
                </c:pt>
                <c:pt idx="21">
                  <c:v>328.7052605177845</c:v>
                </c:pt>
                <c:pt idx="22">
                  <c:v>320.96662716100855</c:v>
                </c:pt>
                <c:pt idx="23">
                  <c:v>327.86900529547802</c:v>
                </c:pt>
                <c:pt idx="24">
                  <c:v>320.15881846821321</c:v>
                </c:pt>
                <c:pt idx="25">
                  <c:v>330.078414361809</c:v>
                </c:pt>
                <c:pt idx="26">
                  <c:v>332.82587688474302</c:v>
                </c:pt>
                <c:pt idx="27">
                  <c:v>348.74406021268203</c:v>
                </c:pt>
                <c:pt idx="28">
                  <c:v>330.60450559872697</c:v>
                </c:pt>
                <c:pt idx="29">
                  <c:v>350.63574560029099</c:v>
                </c:pt>
                <c:pt idx="30">
                  <c:v>344.80361812263197</c:v>
                </c:pt>
                <c:pt idx="31">
                  <c:v>364.9832531993585</c:v>
                </c:pt>
                <c:pt idx="32">
                  <c:v>324.60701491895895</c:v>
                </c:pt>
                <c:pt idx="33">
                  <c:v>330.39757810340649</c:v>
                </c:pt>
                <c:pt idx="34">
                  <c:v>329.39893603572955</c:v>
                </c:pt>
                <c:pt idx="35">
                  <c:v>361.70235244400601</c:v>
                </c:pt>
                <c:pt idx="36">
                  <c:v>327.93460672592153</c:v>
                </c:pt>
                <c:pt idx="37">
                  <c:v>289.69354858763791</c:v>
                </c:pt>
                <c:pt idx="38">
                  <c:v>274.09104713918703</c:v>
                </c:pt>
                <c:pt idx="39">
                  <c:v>263.93431146476553</c:v>
                </c:pt>
                <c:pt idx="40">
                  <c:v>329.10993700467384</c:v>
                </c:pt>
                <c:pt idx="41">
                  <c:v>339.48540149712551</c:v>
                </c:pt>
                <c:pt idx="42">
                  <c:v>324.65486159526847</c:v>
                </c:pt>
                <c:pt idx="43">
                  <c:v>327.87237456528749</c:v>
                </c:pt>
                <c:pt idx="44">
                  <c:v>323.83257498124698</c:v>
                </c:pt>
                <c:pt idx="45">
                  <c:v>322.77365724236648</c:v>
                </c:pt>
                <c:pt idx="46">
                  <c:v>305.3471904979445</c:v>
                </c:pt>
                <c:pt idx="47">
                  <c:v>328.7052605177845</c:v>
                </c:pt>
                <c:pt idx="48">
                  <c:v>320.96662716100855</c:v>
                </c:pt>
                <c:pt idx="49">
                  <c:v>327.86900529547802</c:v>
                </c:pt>
                <c:pt idx="50">
                  <c:v>320.15881846821321</c:v>
                </c:pt>
                <c:pt idx="51">
                  <c:v>330.078414361809</c:v>
                </c:pt>
                <c:pt idx="52">
                  <c:v>332.82587688474302</c:v>
                </c:pt>
                <c:pt idx="53">
                  <c:v>348.74406021268203</c:v>
                </c:pt>
                <c:pt idx="54">
                  <c:v>330.60450559872697</c:v>
                </c:pt>
                <c:pt idx="55">
                  <c:v>350.63574560029099</c:v>
                </c:pt>
                <c:pt idx="56">
                  <c:v>344.80361812263197</c:v>
                </c:pt>
                <c:pt idx="57">
                  <c:v>364.9832531993585</c:v>
                </c:pt>
                <c:pt idx="58">
                  <c:v>324.60701491895895</c:v>
                </c:pt>
                <c:pt idx="59">
                  <c:v>330.39757810340649</c:v>
                </c:pt>
                <c:pt idx="60">
                  <c:v>329.39893603572955</c:v>
                </c:pt>
                <c:pt idx="61">
                  <c:v>361.70235244400601</c:v>
                </c:pt>
                <c:pt idx="62">
                  <c:v>327.93460672592153</c:v>
                </c:pt>
                <c:pt idx="63">
                  <c:v>375.13317275483405</c:v>
                </c:pt>
                <c:pt idx="64">
                  <c:v>333.1379591543045</c:v>
                </c:pt>
                <c:pt idx="65">
                  <c:v>346.53530426054101</c:v>
                </c:pt>
                <c:pt idx="66">
                  <c:v>348.2301449571255</c:v>
                </c:pt>
                <c:pt idx="67">
                  <c:v>331.1401023373765</c:v>
                </c:pt>
                <c:pt idx="68">
                  <c:v>366.86951734196703</c:v>
                </c:pt>
                <c:pt idx="69">
                  <c:v>348.83386913420298</c:v>
                </c:pt>
                <c:pt idx="70">
                  <c:v>345.999757438551</c:v>
                </c:pt>
                <c:pt idx="71">
                  <c:v>365.58025397986501</c:v>
                </c:pt>
                <c:pt idx="72">
                  <c:v>383.93106706296902</c:v>
                </c:pt>
                <c:pt idx="73">
                  <c:v>337.58207348451549</c:v>
                </c:pt>
                <c:pt idx="74">
                  <c:v>355.46773648051749</c:v>
                </c:pt>
                <c:pt idx="75">
                  <c:v>359.35910577352797</c:v>
                </c:pt>
                <c:pt idx="76">
                  <c:v>347.42260399650945</c:v>
                </c:pt>
                <c:pt idx="77">
                  <c:v>346.26379165978403</c:v>
                </c:pt>
                <c:pt idx="78">
                  <c:v>386.79963459196097</c:v>
                </c:pt>
                <c:pt idx="79">
                  <c:v>354.39545485732549</c:v>
                </c:pt>
                <c:pt idx="80">
                  <c:v>311.22821552877951</c:v>
                </c:pt>
                <c:pt idx="81">
                  <c:v>330.01473089928299</c:v>
                </c:pt>
                <c:pt idx="82">
                  <c:v>362.89466130884051</c:v>
                </c:pt>
                <c:pt idx="83">
                  <c:v>334.18673745426349</c:v>
                </c:pt>
                <c:pt idx="84">
                  <c:v>349.67122336020202</c:v>
                </c:pt>
                <c:pt idx="85">
                  <c:v>375.52221445642249</c:v>
                </c:pt>
                <c:pt idx="86">
                  <c:v>341.47379668293695</c:v>
                </c:pt>
                <c:pt idx="87">
                  <c:v>391.31904674647649</c:v>
                </c:pt>
                <c:pt idx="88">
                  <c:v>377.72318120059299</c:v>
                </c:pt>
                <c:pt idx="89">
                  <c:v>345.27508528638651</c:v>
                </c:pt>
                <c:pt idx="90">
                  <c:v>372.86858727279548</c:v>
                </c:pt>
                <c:pt idx="91">
                  <c:v>328.08387397990452</c:v>
                </c:pt>
                <c:pt idx="92">
                  <c:v>369.33792371448396</c:v>
                </c:pt>
                <c:pt idx="93">
                  <c:v>315.08472249593251</c:v>
                </c:pt>
                <c:pt idx="94">
                  <c:v>366.42550855193747</c:v>
                </c:pt>
                <c:pt idx="95">
                  <c:v>375.41551953390103</c:v>
                </c:pt>
                <c:pt idx="96">
                  <c:v>324.33624392211755</c:v>
                </c:pt>
                <c:pt idx="97">
                  <c:v>321.42758248985103</c:v>
                </c:pt>
                <c:pt idx="98">
                  <c:v>372.02778016870354</c:v>
                </c:pt>
                <c:pt idx="99">
                  <c:v>345.598664997914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Fig.6 B'!$M$1</c:f>
              <c:strCache>
                <c:ptCount val="1"/>
                <c:pt idx="0">
                  <c:v>CD38 shRNA</c:v>
                </c:pt>
              </c:strCache>
            </c:strRef>
          </c:tx>
          <c:spPr>
            <a:ln w="1270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Fig.6 B'!$O$2:$O$101</c:f>
                <c:numCache>
                  <c:formatCode>General</c:formatCode>
                  <c:ptCount val="100"/>
                  <c:pt idx="0">
                    <c:v>0</c:v>
                  </c:pt>
                  <c:pt idx="1">
                    <c:v>1.4839342909980919</c:v>
                  </c:pt>
                  <c:pt idx="2">
                    <c:v>8.9361252633466499</c:v>
                  </c:pt>
                  <c:pt idx="3">
                    <c:v>8.3329646885127229</c:v>
                  </c:pt>
                  <c:pt idx="4">
                    <c:v>10.104350537620986</c:v>
                  </c:pt>
                  <c:pt idx="5">
                    <c:v>12.541360420712904</c:v>
                  </c:pt>
                  <c:pt idx="6">
                    <c:v>11.284023582924702</c:v>
                  </c:pt>
                  <c:pt idx="7">
                    <c:v>9.4919189219979927</c:v>
                  </c:pt>
                  <c:pt idx="8">
                    <c:v>11.450244538097134</c:v>
                  </c:pt>
                  <c:pt idx="9">
                    <c:v>15.249295520978503</c:v>
                  </c:pt>
                  <c:pt idx="10">
                    <c:v>25.696792610845069</c:v>
                  </c:pt>
                  <c:pt idx="11">
                    <c:v>16.841756210505483</c:v>
                  </c:pt>
                  <c:pt idx="12">
                    <c:v>10.441848956330142</c:v>
                  </c:pt>
                  <c:pt idx="13">
                    <c:v>10.513581151187312</c:v>
                  </c:pt>
                  <c:pt idx="14">
                    <c:v>13.714620958535253</c:v>
                  </c:pt>
                  <c:pt idx="15">
                    <c:v>11.981850885759975</c:v>
                  </c:pt>
                  <c:pt idx="16">
                    <c:v>14.070108568578171</c:v>
                  </c:pt>
                  <c:pt idx="17">
                    <c:v>11.475916216246404</c:v>
                  </c:pt>
                  <c:pt idx="18">
                    <c:v>11.8707856780944</c:v>
                  </c:pt>
                  <c:pt idx="19">
                    <c:v>9.9285138771072159</c:v>
                  </c:pt>
                  <c:pt idx="20">
                    <c:v>11.6570466396253</c:v>
                  </c:pt>
                  <c:pt idx="21">
                    <c:v>12.203572798039325</c:v>
                  </c:pt>
                  <c:pt idx="22">
                    <c:v>14.933787393551667</c:v>
                  </c:pt>
                  <c:pt idx="23">
                    <c:v>9.9198516651092472</c:v>
                  </c:pt>
                  <c:pt idx="24">
                    <c:v>11.525285769561908</c:v>
                  </c:pt>
                  <c:pt idx="25">
                    <c:v>13.119921510990013</c:v>
                  </c:pt>
                  <c:pt idx="26">
                    <c:v>13.558820674007583</c:v>
                  </c:pt>
                  <c:pt idx="27">
                    <c:v>12.817933648719983</c:v>
                  </c:pt>
                  <c:pt idx="28">
                    <c:v>11.962629638429481</c:v>
                  </c:pt>
                  <c:pt idx="29">
                    <c:v>11.661513384166058</c:v>
                  </c:pt>
                  <c:pt idx="30">
                    <c:v>11.41875119196949</c:v>
                  </c:pt>
                  <c:pt idx="31">
                    <c:v>14.16196690456103</c:v>
                  </c:pt>
                  <c:pt idx="32">
                    <c:v>15.347421159914342</c:v>
                  </c:pt>
                  <c:pt idx="33">
                    <c:v>10.137687572402905</c:v>
                  </c:pt>
                  <c:pt idx="34">
                    <c:v>10.076177871543635</c:v>
                  </c:pt>
                  <c:pt idx="35">
                    <c:v>8.8857556433767879</c:v>
                  </c:pt>
                  <c:pt idx="36">
                    <c:v>12.5852299397301</c:v>
                  </c:pt>
                  <c:pt idx="37">
                    <c:v>7.1913223075586616</c:v>
                  </c:pt>
                  <c:pt idx="38">
                    <c:v>15.224963702906384</c:v>
                  </c:pt>
                  <c:pt idx="39">
                    <c:v>15.789039260051787</c:v>
                  </c:pt>
                  <c:pt idx="40">
                    <c:v>15.068553810509442</c:v>
                  </c:pt>
                  <c:pt idx="41">
                    <c:v>15.716666052761825</c:v>
                  </c:pt>
                  <c:pt idx="42">
                    <c:v>14.969646138672642</c:v>
                  </c:pt>
                  <c:pt idx="43">
                    <c:v>15.32434194752418</c:v>
                  </c:pt>
                  <c:pt idx="44">
                    <c:v>17.411337985880227</c:v>
                  </c:pt>
                  <c:pt idx="45">
                    <c:v>17.0395567472039</c:v>
                  </c:pt>
                  <c:pt idx="46">
                    <c:v>14.879593444170439</c:v>
                  </c:pt>
                  <c:pt idx="47">
                    <c:v>17.382233938865554</c:v>
                  </c:pt>
                  <c:pt idx="48">
                    <c:v>16.477698456687257</c:v>
                  </c:pt>
                  <c:pt idx="49">
                    <c:v>16.184009444491519</c:v>
                  </c:pt>
                  <c:pt idx="50">
                    <c:v>15.417674337862278</c:v>
                  </c:pt>
                  <c:pt idx="51">
                    <c:v>18.270864030672342</c:v>
                  </c:pt>
                  <c:pt idx="52">
                    <c:v>19.661176952859623</c:v>
                  </c:pt>
                  <c:pt idx="53">
                    <c:v>20.755370452080001</c:v>
                  </c:pt>
                  <c:pt idx="54">
                    <c:v>21.403858735952852</c:v>
                  </c:pt>
                  <c:pt idx="55">
                    <c:v>17.428453348471582</c:v>
                  </c:pt>
                  <c:pt idx="56">
                    <c:v>19.26270496142028</c:v>
                  </c:pt>
                  <c:pt idx="57">
                    <c:v>17.121508391083669</c:v>
                  </c:pt>
                  <c:pt idx="58">
                    <c:v>16.437529160765521</c:v>
                  </c:pt>
                  <c:pt idx="59">
                    <c:v>19.841086509177408</c:v>
                  </c:pt>
                  <c:pt idx="60">
                    <c:v>17.267832322892158</c:v>
                  </c:pt>
                  <c:pt idx="61">
                    <c:v>18.623870945082672</c:v>
                  </c:pt>
                  <c:pt idx="62">
                    <c:v>18.211938327511739</c:v>
                  </c:pt>
                  <c:pt idx="63">
                    <c:v>19.880190967532858</c:v>
                  </c:pt>
                  <c:pt idx="64">
                    <c:v>15.838726974434113</c:v>
                  </c:pt>
                  <c:pt idx="65">
                    <c:v>16.451702255269353</c:v>
                  </c:pt>
                  <c:pt idx="66">
                    <c:v>16.863672584188951</c:v>
                  </c:pt>
                  <c:pt idx="67">
                    <c:v>16.273554226910466</c:v>
                  </c:pt>
                  <c:pt idx="68">
                    <c:v>15.879510368602416</c:v>
                  </c:pt>
                  <c:pt idx="69">
                    <c:v>14.961399532533987</c:v>
                  </c:pt>
                  <c:pt idx="70">
                    <c:v>17.838953379989466</c:v>
                  </c:pt>
                  <c:pt idx="71">
                    <c:v>17.649346422781896</c:v>
                  </c:pt>
                  <c:pt idx="72">
                    <c:v>17.621570942455339</c:v>
                  </c:pt>
                  <c:pt idx="73">
                    <c:v>18.725915009003547</c:v>
                  </c:pt>
                  <c:pt idx="74">
                    <c:v>16.243224449034013</c:v>
                  </c:pt>
                  <c:pt idx="75">
                    <c:v>19.414118918835658</c:v>
                  </c:pt>
                  <c:pt idx="76">
                    <c:v>16.620286642534708</c:v>
                  </c:pt>
                  <c:pt idx="77">
                    <c:v>20.377897063823958</c:v>
                  </c:pt>
                  <c:pt idx="78">
                    <c:v>20.711590437829429</c:v>
                  </c:pt>
                  <c:pt idx="79">
                    <c:v>16.896167115850044</c:v>
                  </c:pt>
                  <c:pt idx="80">
                    <c:v>15.825062432554724</c:v>
                  </c:pt>
                  <c:pt idx="81">
                    <c:v>19.754039323697562</c:v>
                  </c:pt>
                  <c:pt idx="82">
                    <c:v>16.10353243089795</c:v>
                  </c:pt>
                  <c:pt idx="83">
                    <c:v>17.460360602564823</c:v>
                  </c:pt>
                  <c:pt idx="84">
                    <c:v>16.942966277395101</c:v>
                  </c:pt>
                  <c:pt idx="85">
                    <c:v>19.705818250302304</c:v>
                  </c:pt>
                  <c:pt idx="86">
                    <c:v>19.122708380121107</c:v>
                  </c:pt>
                  <c:pt idx="87">
                    <c:v>17.03484856661828</c:v>
                  </c:pt>
                  <c:pt idx="88">
                    <c:v>16.620286642534708</c:v>
                  </c:pt>
                  <c:pt idx="89">
                    <c:v>16.418998230520316</c:v>
                  </c:pt>
                  <c:pt idx="90">
                    <c:v>22.474733535027148</c:v>
                  </c:pt>
                  <c:pt idx="91">
                    <c:v>15.984793292222131</c:v>
                  </c:pt>
                  <c:pt idx="92">
                    <c:v>16.403185971683083</c:v>
                  </c:pt>
                  <c:pt idx="93">
                    <c:v>17.900292866789972</c:v>
                  </c:pt>
                  <c:pt idx="94">
                    <c:v>17.757503979482166</c:v>
                  </c:pt>
                  <c:pt idx="95">
                    <c:v>18.431826411766774</c:v>
                  </c:pt>
                  <c:pt idx="96">
                    <c:v>18.201022641174372</c:v>
                  </c:pt>
                  <c:pt idx="97">
                    <c:v>19.308565624041155</c:v>
                  </c:pt>
                  <c:pt idx="98">
                    <c:v>16.624114925354618</c:v>
                  </c:pt>
                  <c:pt idx="99">
                    <c:v>19.017810395680208</c:v>
                  </c:pt>
                </c:numCache>
              </c:numRef>
            </c:plus>
            <c:minus>
              <c:numRef>
                <c:f>'Fig.6 B'!$O$2:$O$101</c:f>
                <c:numCache>
                  <c:formatCode>General</c:formatCode>
                  <c:ptCount val="100"/>
                  <c:pt idx="0">
                    <c:v>0</c:v>
                  </c:pt>
                  <c:pt idx="1">
                    <c:v>1.4839342909980919</c:v>
                  </c:pt>
                  <c:pt idx="2">
                    <c:v>8.9361252633466499</c:v>
                  </c:pt>
                  <c:pt idx="3">
                    <c:v>8.3329646885127229</c:v>
                  </c:pt>
                  <c:pt idx="4">
                    <c:v>10.104350537620986</c:v>
                  </c:pt>
                  <c:pt idx="5">
                    <c:v>12.541360420712904</c:v>
                  </c:pt>
                  <c:pt idx="6">
                    <c:v>11.284023582924702</c:v>
                  </c:pt>
                  <c:pt idx="7">
                    <c:v>9.4919189219979927</c:v>
                  </c:pt>
                  <c:pt idx="8">
                    <c:v>11.450244538097134</c:v>
                  </c:pt>
                  <c:pt idx="9">
                    <c:v>15.249295520978503</c:v>
                  </c:pt>
                  <c:pt idx="10">
                    <c:v>25.696792610845069</c:v>
                  </c:pt>
                  <c:pt idx="11">
                    <c:v>16.841756210505483</c:v>
                  </c:pt>
                  <c:pt idx="12">
                    <c:v>10.441848956330142</c:v>
                  </c:pt>
                  <c:pt idx="13">
                    <c:v>10.513581151187312</c:v>
                  </c:pt>
                  <c:pt idx="14">
                    <c:v>13.714620958535253</c:v>
                  </c:pt>
                  <c:pt idx="15">
                    <c:v>11.981850885759975</c:v>
                  </c:pt>
                  <c:pt idx="16">
                    <c:v>14.070108568578171</c:v>
                  </c:pt>
                  <c:pt idx="17">
                    <c:v>11.475916216246404</c:v>
                  </c:pt>
                  <c:pt idx="18">
                    <c:v>11.8707856780944</c:v>
                  </c:pt>
                  <c:pt idx="19">
                    <c:v>9.9285138771072159</c:v>
                  </c:pt>
                  <c:pt idx="20">
                    <c:v>11.6570466396253</c:v>
                  </c:pt>
                  <c:pt idx="21">
                    <c:v>12.203572798039325</c:v>
                  </c:pt>
                  <c:pt idx="22">
                    <c:v>14.933787393551667</c:v>
                  </c:pt>
                  <c:pt idx="23">
                    <c:v>9.9198516651092472</c:v>
                  </c:pt>
                  <c:pt idx="24">
                    <c:v>11.525285769561908</c:v>
                  </c:pt>
                  <c:pt idx="25">
                    <c:v>13.119921510990013</c:v>
                  </c:pt>
                  <c:pt idx="26">
                    <c:v>13.558820674007583</c:v>
                  </c:pt>
                  <c:pt idx="27">
                    <c:v>12.817933648719983</c:v>
                  </c:pt>
                  <c:pt idx="28">
                    <c:v>11.962629638429481</c:v>
                  </c:pt>
                  <c:pt idx="29">
                    <c:v>11.661513384166058</c:v>
                  </c:pt>
                  <c:pt idx="30">
                    <c:v>11.41875119196949</c:v>
                  </c:pt>
                  <c:pt idx="31">
                    <c:v>14.16196690456103</c:v>
                  </c:pt>
                  <c:pt idx="32">
                    <c:v>15.347421159914342</c:v>
                  </c:pt>
                  <c:pt idx="33">
                    <c:v>10.137687572402905</c:v>
                  </c:pt>
                  <c:pt idx="34">
                    <c:v>10.076177871543635</c:v>
                  </c:pt>
                  <c:pt idx="35">
                    <c:v>8.8857556433767879</c:v>
                  </c:pt>
                  <c:pt idx="36">
                    <c:v>12.5852299397301</c:v>
                  </c:pt>
                  <c:pt idx="37">
                    <c:v>7.1913223075586616</c:v>
                  </c:pt>
                  <c:pt idx="38">
                    <c:v>15.224963702906384</c:v>
                  </c:pt>
                  <c:pt idx="39">
                    <c:v>15.789039260051787</c:v>
                  </c:pt>
                  <c:pt idx="40">
                    <c:v>15.068553810509442</c:v>
                  </c:pt>
                  <c:pt idx="41">
                    <c:v>15.716666052761825</c:v>
                  </c:pt>
                  <c:pt idx="42">
                    <c:v>14.969646138672642</c:v>
                  </c:pt>
                  <c:pt idx="43">
                    <c:v>15.32434194752418</c:v>
                  </c:pt>
                  <c:pt idx="44">
                    <c:v>17.411337985880227</c:v>
                  </c:pt>
                  <c:pt idx="45">
                    <c:v>17.0395567472039</c:v>
                  </c:pt>
                  <c:pt idx="46">
                    <c:v>14.879593444170439</c:v>
                  </c:pt>
                  <c:pt idx="47">
                    <c:v>17.382233938865554</c:v>
                  </c:pt>
                  <c:pt idx="48">
                    <c:v>16.477698456687257</c:v>
                  </c:pt>
                  <c:pt idx="49">
                    <c:v>16.184009444491519</c:v>
                  </c:pt>
                  <c:pt idx="50">
                    <c:v>15.417674337862278</c:v>
                  </c:pt>
                  <c:pt idx="51">
                    <c:v>18.270864030672342</c:v>
                  </c:pt>
                  <c:pt idx="52">
                    <c:v>19.661176952859623</c:v>
                  </c:pt>
                  <c:pt idx="53">
                    <c:v>20.755370452080001</c:v>
                  </c:pt>
                  <c:pt idx="54">
                    <c:v>21.403858735952852</c:v>
                  </c:pt>
                  <c:pt idx="55">
                    <c:v>17.428453348471582</c:v>
                  </c:pt>
                  <c:pt idx="56">
                    <c:v>19.26270496142028</c:v>
                  </c:pt>
                  <c:pt idx="57">
                    <c:v>17.121508391083669</c:v>
                  </c:pt>
                  <c:pt idx="58">
                    <c:v>16.437529160765521</c:v>
                  </c:pt>
                  <c:pt idx="59">
                    <c:v>19.841086509177408</c:v>
                  </c:pt>
                  <c:pt idx="60">
                    <c:v>17.267832322892158</c:v>
                  </c:pt>
                  <c:pt idx="61">
                    <c:v>18.623870945082672</c:v>
                  </c:pt>
                  <c:pt idx="62">
                    <c:v>18.211938327511739</c:v>
                  </c:pt>
                  <c:pt idx="63">
                    <c:v>19.880190967532858</c:v>
                  </c:pt>
                  <c:pt idx="64">
                    <c:v>15.838726974434113</c:v>
                  </c:pt>
                  <c:pt idx="65">
                    <c:v>16.451702255269353</c:v>
                  </c:pt>
                  <c:pt idx="66">
                    <c:v>16.863672584188951</c:v>
                  </c:pt>
                  <c:pt idx="67">
                    <c:v>16.273554226910466</c:v>
                  </c:pt>
                  <c:pt idx="68">
                    <c:v>15.879510368602416</c:v>
                  </c:pt>
                  <c:pt idx="69">
                    <c:v>14.961399532533987</c:v>
                  </c:pt>
                  <c:pt idx="70">
                    <c:v>17.838953379989466</c:v>
                  </c:pt>
                  <c:pt idx="71">
                    <c:v>17.649346422781896</c:v>
                  </c:pt>
                  <c:pt idx="72">
                    <c:v>17.621570942455339</c:v>
                  </c:pt>
                  <c:pt idx="73">
                    <c:v>18.725915009003547</c:v>
                  </c:pt>
                  <c:pt idx="74">
                    <c:v>16.243224449034013</c:v>
                  </c:pt>
                  <c:pt idx="75">
                    <c:v>19.414118918835658</c:v>
                  </c:pt>
                  <c:pt idx="76">
                    <c:v>16.620286642534708</c:v>
                  </c:pt>
                  <c:pt idx="77">
                    <c:v>20.377897063823958</c:v>
                  </c:pt>
                  <c:pt idx="78">
                    <c:v>20.711590437829429</c:v>
                  </c:pt>
                  <c:pt idx="79">
                    <c:v>16.896167115850044</c:v>
                  </c:pt>
                  <c:pt idx="80">
                    <c:v>15.825062432554724</c:v>
                  </c:pt>
                  <c:pt idx="81">
                    <c:v>19.754039323697562</c:v>
                  </c:pt>
                  <c:pt idx="82">
                    <c:v>16.10353243089795</c:v>
                  </c:pt>
                  <c:pt idx="83">
                    <c:v>17.460360602564823</c:v>
                  </c:pt>
                  <c:pt idx="84">
                    <c:v>16.942966277395101</c:v>
                  </c:pt>
                  <c:pt idx="85">
                    <c:v>19.705818250302304</c:v>
                  </c:pt>
                  <c:pt idx="86">
                    <c:v>19.122708380121107</c:v>
                  </c:pt>
                  <c:pt idx="87">
                    <c:v>17.03484856661828</c:v>
                  </c:pt>
                  <c:pt idx="88">
                    <c:v>16.620286642534708</c:v>
                  </c:pt>
                  <c:pt idx="89">
                    <c:v>16.418998230520316</c:v>
                  </c:pt>
                  <c:pt idx="90">
                    <c:v>22.474733535027148</c:v>
                  </c:pt>
                  <c:pt idx="91">
                    <c:v>15.984793292222131</c:v>
                  </c:pt>
                  <c:pt idx="92">
                    <c:v>16.403185971683083</c:v>
                  </c:pt>
                  <c:pt idx="93">
                    <c:v>17.900292866789972</c:v>
                  </c:pt>
                  <c:pt idx="94">
                    <c:v>17.757503979482166</c:v>
                  </c:pt>
                  <c:pt idx="95">
                    <c:v>18.431826411766774</c:v>
                  </c:pt>
                  <c:pt idx="96">
                    <c:v>18.201022641174372</c:v>
                  </c:pt>
                  <c:pt idx="97">
                    <c:v>19.308565624041155</c:v>
                  </c:pt>
                  <c:pt idx="98">
                    <c:v>16.624114925354618</c:v>
                  </c:pt>
                  <c:pt idx="99">
                    <c:v>19.01781039568020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bg2">
                    <a:lumMod val="90000"/>
                  </a:schemeClr>
                </a:solidFill>
                <a:round/>
              </a:ln>
              <a:effectLst/>
            </c:spPr>
          </c:errBars>
          <c:cat>
            <c:numRef>
              <c:f>'Fig.6 B'!$K$2:$K$101</c:f>
              <c:numCache>
                <c:formatCode>General</c:formatCode>
                <c:ptCount val="100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5</c:v>
                </c:pt>
                <c:pt idx="6">
                  <c:v>18</c:v>
                </c:pt>
                <c:pt idx="7">
                  <c:v>21</c:v>
                </c:pt>
                <c:pt idx="8">
                  <c:v>24</c:v>
                </c:pt>
                <c:pt idx="9">
                  <c:v>27</c:v>
                </c:pt>
                <c:pt idx="10">
                  <c:v>30</c:v>
                </c:pt>
                <c:pt idx="11">
                  <c:v>33</c:v>
                </c:pt>
                <c:pt idx="12">
                  <c:v>36</c:v>
                </c:pt>
                <c:pt idx="13">
                  <c:v>39</c:v>
                </c:pt>
                <c:pt idx="14">
                  <c:v>42</c:v>
                </c:pt>
                <c:pt idx="15">
                  <c:v>45</c:v>
                </c:pt>
                <c:pt idx="16">
                  <c:v>48</c:v>
                </c:pt>
                <c:pt idx="17">
                  <c:v>51</c:v>
                </c:pt>
                <c:pt idx="18">
                  <c:v>54</c:v>
                </c:pt>
                <c:pt idx="19">
                  <c:v>57</c:v>
                </c:pt>
                <c:pt idx="20">
                  <c:v>60</c:v>
                </c:pt>
                <c:pt idx="21">
                  <c:v>63</c:v>
                </c:pt>
                <c:pt idx="22">
                  <c:v>66</c:v>
                </c:pt>
                <c:pt idx="23">
                  <c:v>69</c:v>
                </c:pt>
                <c:pt idx="24">
                  <c:v>72</c:v>
                </c:pt>
                <c:pt idx="25">
                  <c:v>75</c:v>
                </c:pt>
                <c:pt idx="26">
                  <c:v>78</c:v>
                </c:pt>
                <c:pt idx="27">
                  <c:v>81</c:v>
                </c:pt>
                <c:pt idx="28">
                  <c:v>84</c:v>
                </c:pt>
                <c:pt idx="29">
                  <c:v>87</c:v>
                </c:pt>
                <c:pt idx="30">
                  <c:v>90</c:v>
                </c:pt>
                <c:pt idx="31">
                  <c:v>93</c:v>
                </c:pt>
                <c:pt idx="32">
                  <c:v>96</c:v>
                </c:pt>
                <c:pt idx="33">
                  <c:v>99</c:v>
                </c:pt>
                <c:pt idx="34">
                  <c:v>102</c:v>
                </c:pt>
                <c:pt idx="35">
                  <c:v>105</c:v>
                </c:pt>
                <c:pt idx="36">
                  <c:v>108</c:v>
                </c:pt>
                <c:pt idx="37">
                  <c:v>111</c:v>
                </c:pt>
                <c:pt idx="38">
                  <c:v>114</c:v>
                </c:pt>
                <c:pt idx="39">
                  <c:v>117</c:v>
                </c:pt>
                <c:pt idx="40">
                  <c:v>120</c:v>
                </c:pt>
                <c:pt idx="41">
                  <c:v>123</c:v>
                </c:pt>
                <c:pt idx="42">
                  <c:v>126</c:v>
                </c:pt>
                <c:pt idx="43">
                  <c:v>129</c:v>
                </c:pt>
                <c:pt idx="44">
                  <c:v>132</c:v>
                </c:pt>
                <c:pt idx="45">
                  <c:v>135</c:v>
                </c:pt>
                <c:pt idx="46">
                  <c:v>138</c:v>
                </c:pt>
                <c:pt idx="47">
                  <c:v>141</c:v>
                </c:pt>
                <c:pt idx="48">
                  <c:v>144</c:v>
                </c:pt>
                <c:pt idx="49">
                  <c:v>147</c:v>
                </c:pt>
                <c:pt idx="50">
                  <c:v>150</c:v>
                </c:pt>
                <c:pt idx="51">
                  <c:v>153</c:v>
                </c:pt>
                <c:pt idx="52">
                  <c:v>156</c:v>
                </c:pt>
                <c:pt idx="53">
                  <c:v>159</c:v>
                </c:pt>
                <c:pt idx="54">
                  <c:v>162</c:v>
                </c:pt>
                <c:pt idx="55">
                  <c:v>165</c:v>
                </c:pt>
                <c:pt idx="56">
                  <c:v>168</c:v>
                </c:pt>
                <c:pt idx="57">
                  <c:v>171</c:v>
                </c:pt>
                <c:pt idx="58">
                  <c:v>174</c:v>
                </c:pt>
                <c:pt idx="59">
                  <c:v>177</c:v>
                </c:pt>
                <c:pt idx="60">
                  <c:v>180</c:v>
                </c:pt>
                <c:pt idx="61">
                  <c:v>183</c:v>
                </c:pt>
                <c:pt idx="62">
                  <c:v>186</c:v>
                </c:pt>
                <c:pt idx="63">
                  <c:v>189</c:v>
                </c:pt>
                <c:pt idx="64">
                  <c:v>192</c:v>
                </c:pt>
                <c:pt idx="65">
                  <c:v>195</c:v>
                </c:pt>
                <c:pt idx="66">
                  <c:v>198</c:v>
                </c:pt>
                <c:pt idx="67">
                  <c:v>201</c:v>
                </c:pt>
                <c:pt idx="68">
                  <c:v>204</c:v>
                </c:pt>
                <c:pt idx="69">
                  <c:v>207</c:v>
                </c:pt>
                <c:pt idx="70">
                  <c:v>210</c:v>
                </c:pt>
                <c:pt idx="71">
                  <c:v>213</c:v>
                </c:pt>
                <c:pt idx="72">
                  <c:v>216</c:v>
                </c:pt>
                <c:pt idx="73">
                  <c:v>219</c:v>
                </c:pt>
                <c:pt idx="74">
                  <c:v>222</c:v>
                </c:pt>
                <c:pt idx="75">
                  <c:v>225</c:v>
                </c:pt>
                <c:pt idx="76">
                  <c:v>228</c:v>
                </c:pt>
                <c:pt idx="77">
                  <c:v>231</c:v>
                </c:pt>
                <c:pt idx="78">
                  <c:v>234</c:v>
                </c:pt>
                <c:pt idx="79">
                  <c:v>237</c:v>
                </c:pt>
                <c:pt idx="80">
                  <c:v>240</c:v>
                </c:pt>
                <c:pt idx="81">
                  <c:v>243</c:v>
                </c:pt>
                <c:pt idx="82">
                  <c:v>246</c:v>
                </c:pt>
                <c:pt idx="83">
                  <c:v>249</c:v>
                </c:pt>
                <c:pt idx="84">
                  <c:v>252</c:v>
                </c:pt>
                <c:pt idx="85">
                  <c:v>255</c:v>
                </c:pt>
                <c:pt idx="86">
                  <c:v>258</c:v>
                </c:pt>
                <c:pt idx="87">
                  <c:v>261</c:v>
                </c:pt>
                <c:pt idx="88">
                  <c:v>264</c:v>
                </c:pt>
                <c:pt idx="89">
                  <c:v>267</c:v>
                </c:pt>
                <c:pt idx="90">
                  <c:v>270</c:v>
                </c:pt>
                <c:pt idx="91">
                  <c:v>273</c:v>
                </c:pt>
                <c:pt idx="92">
                  <c:v>276</c:v>
                </c:pt>
                <c:pt idx="93">
                  <c:v>279</c:v>
                </c:pt>
                <c:pt idx="94">
                  <c:v>282</c:v>
                </c:pt>
                <c:pt idx="95">
                  <c:v>285</c:v>
                </c:pt>
                <c:pt idx="96">
                  <c:v>288</c:v>
                </c:pt>
                <c:pt idx="97">
                  <c:v>291</c:v>
                </c:pt>
                <c:pt idx="98">
                  <c:v>294</c:v>
                </c:pt>
                <c:pt idx="99">
                  <c:v>297</c:v>
                </c:pt>
              </c:numCache>
            </c:numRef>
          </c:cat>
          <c:val>
            <c:numRef>
              <c:f>'Fig.6 B'!$M$2:$M$101</c:f>
              <c:numCache>
                <c:formatCode>General</c:formatCode>
                <c:ptCount val="100"/>
                <c:pt idx="0">
                  <c:v>82.5</c:v>
                </c:pt>
                <c:pt idx="1">
                  <c:v>82.5</c:v>
                </c:pt>
                <c:pt idx="2">
                  <c:v>92.638750000000002</c:v>
                </c:pt>
                <c:pt idx="3">
                  <c:v>92.55</c:v>
                </c:pt>
                <c:pt idx="4">
                  <c:v>95.022879593197729</c:v>
                </c:pt>
                <c:pt idx="5">
                  <c:v>97.369799999999998</c:v>
                </c:pt>
                <c:pt idx="6">
                  <c:v>95.671500000000009</c:v>
                </c:pt>
                <c:pt idx="7">
                  <c:v>94.571316516516518</c:v>
                </c:pt>
                <c:pt idx="8">
                  <c:v>96.5184</c:v>
                </c:pt>
                <c:pt idx="9">
                  <c:v>98.851879593197737</c:v>
                </c:pt>
                <c:pt idx="10">
                  <c:v>138.72285915569651</c:v>
                </c:pt>
                <c:pt idx="11">
                  <c:v>90.04393729965004</c:v>
                </c:pt>
                <c:pt idx="12">
                  <c:v>93.406369097603587</c:v>
                </c:pt>
                <c:pt idx="13">
                  <c:v>97.458015692589754</c:v>
                </c:pt>
                <c:pt idx="14">
                  <c:v>97.167524787747482</c:v>
                </c:pt>
                <c:pt idx="15">
                  <c:v>96.286614558636842</c:v>
                </c:pt>
                <c:pt idx="16">
                  <c:v>93.916982674447652</c:v>
                </c:pt>
                <c:pt idx="17">
                  <c:v>93.860467638533237</c:v>
                </c:pt>
                <c:pt idx="18">
                  <c:v>95.880803620506441</c:v>
                </c:pt>
                <c:pt idx="19">
                  <c:v>91.800541866436333</c:v>
                </c:pt>
                <c:pt idx="20">
                  <c:v>94.180725003523534</c:v>
                </c:pt>
                <c:pt idx="21">
                  <c:v>95.144887327471679</c:v>
                </c:pt>
                <c:pt idx="22">
                  <c:v>92.950686232391988</c:v>
                </c:pt>
                <c:pt idx="23">
                  <c:v>93.729068698226286</c:v>
                </c:pt>
                <c:pt idx="24">
                  <c:v>96.456750646340936</c:v>
                </c:pt>
                <c:pt idx="25">
                  <c:v>94.811239999498497</c:v>
                </c:pt>
                <c:pt idx="26">
                  <c:v>96.270330073723599</c:v>
                </c:pt>
                <c:pt idx="27">
                  <c:v>97.830730024221481</c:v>
                </c:pt>
                <c:pt idx="28">
                  <c:v>97.022042876550898</c:v>
                </c:pt>
                <c:pt idx="29">
                  <c:v>98.240429505135396</c:v>
                </c:pt>
                <c:pt idx="30">
                  <c:v>93.968153048658252</c:v>
                </c:pt>
                <c:pt idx="31">
                  <c:v>96.065987288149216</c:v>
                </c:pt>
                <c:pt idx="32">
                  <c:v>98.706620793169662</c:v>
                </c:pt>
                <c:pt idx="33">
                  <c:v>94.894390220899282</c:v>
                </c:pt>
                <c:pt idx="34">
                  <c:v>92.615123585423461</c:v>
                </c:pt>
                <c:pt idx="35">
                  <c:v>92.406576394106366</c:v>
                </c:pt>
                <c:pt idx="36">
                  <c:v>97.811130838377778</c:v>
                </c:pt>
                <c:pt idx="37">
                  <c:v>98.655285506904207</c:v>
                </c:pt>
                <c:pt idx="38">
                  <c:v>87.755597773248894</c:v>
                </c:pt>
                <c:pt idx="39">
                  <c:v>87.23588385186639</c:v>
                </c:pt>
                <c:pt idx="40">
                  <c:v>84.216288537624962</c:v>
                </c:pt>
                <c:pt idx="41">
                  <c:v>89.234414310994453</c:v>
                </c:pt>
                <c:pt idx="42">
                  <c:v>95.090480297633675</c:v>
                </c:pt>
                <c:pt idx="43">
                  <c:v>90.934128908340938</c:v>
                </c:pt>
                <c:pt idx="44">
                  <c:v>90.206692394302536</c:v>
                </c:pt>
                <c:pt idx="45">
                  <c:v>94.092077856783746</c:v>
                </c:pt>
                <c:pt idx="46">
                  <c:v>92.252421215667297</c:v>
                </c:pt>
                <c:pt idx="47">
                  <c:v>96.741146701427425</c:v>
                </c:pt>
                <c:pt idx="48">
                  <c:v>97.5442174263043</c:v>
                </c:pt>
                <c:pt idx="49">
                  <c:v>99.915833800959689</c:v>
                </c:pt>
                <c:pt idx="50">
                  <c:v>101.33203547539304</c:v>
                </c:pt>
                <c:pt idx="51">
                  <c:v>110.47102684399246</c:v>
                </c:pt>
                <c:pt idx="52">
                  <c:v>99.59082553516896</c:v>
                </c:pt>
                <c:pt idx="53">
                  <c:v>100.56334659001419</c:v>
                </c:pt>
                <c:pt idx="54">
                  <c:v>100.92539932663695</c:v>
                </c:pt>
                <c:pt idx="55">
                  <c:v>99.077785807480339</c:v>
                </c:pt>
                <c:pt idx="56">
                  <c:v>104.33252983126457</c:v>
                </c:pt>
                <c:pt idx="57">
                  <c:v>95.200397070403028</c:v>
                </c:pt>
                <c:pt idx="58">
                  <c:v>100.60198675043927</c:v>
                </c:pt>
                <c:pt idx="59">
                  <c:v>103.35999574986283</c:v>
                </c:pt>
                <c:pt idx="60">
                  <c:v>103.47827916388692</c:v>
                </c:pt>
                <c:pt idx="61">
                  <c:v>98.891736737175009</c:v>
                </c:pt>
                <c:pt idx="62">
                  <c:v>105.67988736704257</c:v>
                </c:pt>
                <c:pt idx="63">
                  <c:v>97.25901298802151</c:v>
                </c:pt>
                <c:pt idx="64">
                  <c:v>96.627490521900455</c:v>
                </c:pt>
                <c:pt idx="65">
                  <c:v>98.58804389382837</c:v>
                </c:pt>
                <c:pt idx="66">
                  <c:v>94.778070969618966</c:v>
                </c:pt>
                <c:pt idx="67">
                  <c:v>101.58386038474927</c:v>
                </c:pt>
                <c:pt idx="68">
                  <c:v>96.192238288585031</c:v>
                </c:pt>
                <c:pt idx="69">
                  <c:v>96.537505440827971</c:v>
                </c:pt>
                <c:pt idx="70">
                  <c:v>97.166093787882602</c:v>
                </c:pt>
                <c:pt idx="71">
                  <c:v>101.43466321947444</c:v>
                </c:pt>
                <c:pt idx="72">
                  <c:v>108.12918471483565</c:v>
                </c:pt>
                <c:pt idx="73">
                  <c:v>98.025808336579672</c:v>
                </c:pt>
                <c:pt idx="74">
                  <c:v>105.52328152217608</c:v>
                </c:pt>
                <c:pt idx="75">
                  <c:v>101.15912731130709</c:v>
                </c:pt>
                <c:pt idx="76">
                  <c:v>99.190514249177937</c:v>
                </c:pt>
                <c:pt idx="77">
                  <c:v>107.82183196926167</c:v>
                </c:pt>
                <c:pt idx="78">
                  <c:v>100.21411438018697</c:v>
                </c:pt>
                <c:pt idx="79">
                  <c:v>95.805210590966681</c:v>
                </c:pt>
                <c:pt idx="80">
                  <c:v>105.58807377018292</c:v>
                </c:pt>
                <c:pt idx="81">
                  <c:v>98.98421402603725</c:v>
                </c:pt>
                <c:pt idx="82">
                  <c:v>96.265154816204344</c:v>
                </c:pt>
                <c:pt idx="83">
                  <c:v>100.12384259891064</c:v>
                </c:pt>
                <c:pt idx="84">
                  <c:v>105.36887246558939</c:v>
                </c:pt>
                <c:pt idx="85">
                  <c:v>109.44702714761826</c:v>
                </c:pt>
                <c:pt idx="86">
                  <c:v>105.7580776143582</c:v>
                </c:pt>
                <c:pt idx="87">
                  <c:v>111.74101127506465</c:v>
                </c:pt>
                <c:pt idx="88">
                  <c:v>99.190514249177937</c:v>
                </c:pt>
                <c:pt idx="89">
                  <c:v>100.42726326231134</c:v>
                </c:pt>
                <c:pt idx="90">
                  <c:v>105.35422180483225</c:v>
                </c:pt>
                <c:pt idx="91">
                  <c:v>97.745233469907475</c:v>
                </c:pt>
                <c:pt idx="92">
                  <c:v>107.50045175508964</c:v>
                </c:pt>
                <c:pt idx="93">
                  <c:v>105.59775004828448</c:v>
                </c:pt>
                <c:pt idx="94">
                  <c:v>113.99908125274095</c:v>
                </c:pt>
                <c:pt idx="95">
                  <c:v>101.07247722412166</c:v>
                </c:pt>
                <c:pt idx="96">
                  <c:v>113.14013900212075</c:v>
                </c:pt>
                <c:pt idx="97">
                  <c:v>106.92156587388078</c:v>
                </c:pt>
                <c:pt idx="98">
                  <c:v>105.21189454260961</c:v>
                </c:pt>
                <c:pt idx="99">
                  <c:v>104.42205988665046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258621760"/>
        <c:axId val="258622152"/>
      </c:lineChart>
      <c:catAx>
        <c:axId val="2586217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2400000" spcFirstLastPara="1" vertOverflow="ellipsis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258622152"/>
        <c:crosses val="autoZero"/>
        <c:auto val="1"/>
        <c:lblAlgn val="ctr"/>
        <c:lblOffset val="100"/>
        <c:tickLblSkip val="10"/>
        <c:tickMarkSkip val="5"/>
        <c:noMultiLvlLbl val="0"/>
      </c:catAx>
      <c:valAx>
        <c:axId val="258622152"/>
        <c:scaling>
          <c:orientation val="minMax"/>
          <c:max val="6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25862176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46095218478189626"/>
          <c:y val="4.2485970943772877E-2"/>
          <c:w val="0.4402041064724222"/>
          <c:h val="0.1605398691360762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ko-K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'Fig.6 A'!$D$2:$D$3</c:f>
                <c:numCache>
                  <c:formatCode>General</c:formatCode>
                  <c:ptCount val="2"/>
                  <c:pt idx="0">
                    <c:v>3.3007327140510002E-2</c:v>
                  </c:pt>
                  <c:pt idx="1">
                    <c:v>8.465965117257408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Fig.6 A'!$B$2:$B$3</c:f>
              <c:strCache>
                <c:ptCount val="2"/>
                <c:pt idx="0">
                  <c:v>Scramble shRNA</c:v>
                </c:pt>
                <c:pt idx="1">
                  <c:v>CD38 shRNA</c:v>
                </c:pt>
              </c:strCache>
            </c:strRef>
          </c:cat>
          <c:val>
            <c:numRef>
              <c:f>'Fig.6 A'!$C$2:$C$3</c:f>
              <c:numCache>
                <c:formatCode>0.00</c:formatCode>
                <c:ptCount val="2"/>
                <c:pt idx="0">
                  <c:v>1</c:v>
                </c:pt>
                <c:pt idx="1">
                  <c:v>0.113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258622544"/>
        <c:axId val="258622936"/>
      </c:barChart>
      <c:catAx>
        <c:axId val="258622544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258622936"/>
        <c:crosses val="autoZero"/>
        <c:auto val="1"/>
        <c:lblAlgn val="ctr"/>
        <c:lblOffset val="100"/>
        <c:noMultiLvlLbl val="0"/>
      </c:catAx>
      <c:valAx>
        <c:axId val="258622936"/>
        <c:scaling>
          <c:orientation val="minMax"/>
        </c:scaling>
        <c:delete val="0"/>
        <c:axPos val="l"/>
        <c:numFmt formatCode="0.00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25862254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4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5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'Fig.6 C'!$E$2:$E$7</c:f>
                <c:numCache>
                  <c:formatCode>General</c:formatCode>
                  <c:ptCount val="6"/>
                  <c:pt idx="0">
                    <c:v>1.42</c:v>
                  </c:pt>
                  <c:pt idx="1">
                    <c:v>3.21</c:v>
                  </c:pt>
                  <c:pt idx="2">
                    <c:v>2.23</c:v>
                  </c:pt>
                  <c:pt idx="3">
                    <c:v>5.6199999999999966</c:v>
                  </c:pt>
                  <c:pt idx="4">
                    <c:v>0.92</c:v>
                  </c:pt>
                  <c:pt idx="5">
                    <c:v>0.8720000000000004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Fig.6 C'!$C$2:$C$7</c:f>
              <c:strCache>
                <c:ptCount val="6"/>
                <c:pt idx="0">
                  <c:v>CON</c:v>
                </c:pt>
                <c:pt idx="1">
                  <c:v>ISO</c:v>
                </c:pt>
                <c:pt idx="2">
                  <c:v>Scr shRNA CON</c:v>
                </c:pt>
                <c:pt idx="3">
                  <c:v>Scr shRNA + ISO</c:v>
                </c:pt>
                <c:pt idx="4">
                  <c:v>CD38 shRNA CON</c:v>
                </c:pt>
                <c:pt idx="5">
                  <c:v>CD38 shRNA + ISO</c:v>
                </c:pt>
              </c:strCache>
            </c:strRef>
          </c:cat>
          <c:val>
            <c:numRef>
              <c:f>'Fig.6 C'!$D$2:$D$7</c:f>
              <c:numCache>
                <c:formatCode>General</c:formatCode>
                <c:ptCount val="6"/>
                <c:pt idx="0">
                  <c:v>12.528700000000001</c:v>
                </c:pt>
                <c:pt idx="1">
                  <c:v>66.60929999999999</c:v>
                </c:pt>
                <c:pt idx="2">
                  <c:v>12.9457</c:v>
                </c:pt>
                <c:pt idx="3">
                  <c:v>67.2059</c:v>
                </c:pt>
                <c:pt idx="4">
                  <c:v>11.47</c:v>
                </c:pt>
                <c:pt idx="5">
                  <c:v>11.9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258625288"/>
        <c:axId val="258618232"/>
      </c:barChart>
      <c:catAx>
        <c:axId val="258625288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2400000" spcFirstLastPara="1" vertOverflow="ellipsis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258618232"/>
        <c:crosses val="autoZero"/>
        <c:auto val="1"/>
        <c:lblAlgn val="ctr"/>
        <c:lblOffset val="100"/>
        <c:noMultiLvlLbl val="0"/>
      </c:catAx>
      <c:valAx>
        <c:axId val="258618232"/>
        <c:scaling>
          <c:orientation val="minMax"/>
          <c:max val="9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2586252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rgbClr val="00B050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4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5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  <a:effectLst/>
            </c:spPr>
          </c:dPt>
          <c:errBars>
            <c:errBarType val="plus"/>
            <c:errValType val="cust"/>
            <c:noEndCap val="0"/>
            <c:plus>
              <c:numRef>
                <c:f>'Fig.6 D'!$F$3:$F$8</c:f>
                <c:numCache>
                  <c:formatCode>General</c:formatCode>
                  <c:ptCount val="6"/>
                  <c:pt idx="0">
                    <c:v>0.42000000000000021</c:v>
                  </c:pt>
                  <c:pt idx="1">
                    <c:v>1.31</c:v>
                  </c:pt>
                  <c:pt idx="2">
                    <c:v>0.8300000000000004</c:v>
                  </c:pt>
                  <c:pt idx="3">
                    <c:v>1.9820000000000009</c:v>
                  </c:pt>
                  <c:pt idx="4">
                    <c:v>1.32</c:v>
                  </c:pt>
                  <c:pt idx="5">
                    <c:v>0.3200000000000002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Fig.6 D'!$D$3:$D$8</c:f>
              <c:strCache>
                <c:ptCount val="6"/>
                <c:pt idx="0">
                  <c:v>CON</c:v>
                </c:pt>
                <c:pt idx="1">
                  <c:v>ISO</c:v>
                </c:pt>
                <c:pt idx="2">
                  <c:v>Scr shRNA CON</c:v>
                </c:pt>
                <c:pt idx="3">
                  <c:v>Scr shRNA + ISO</c:v>
                </c:pt>
                <c:pt idx="4">
                  <c:v>CD38 shRNA CON</c:v>
                </c:pt>
                <c:pt idx="5">
                  <c:v>CD38 shRNA + ISO</c:v>
                </c:pt>
              </c:strCache>
            </c:strRef>
          </c:cat>
          <c:val>
            <c:numRef>
              <c:f>'Fig.6 D'!$E$3:$E$8</c:f>
              <c:numCache>
                <c:formatCode>General</c:formatCode>
                <c:ptCount val="6"/>
                <c:pt idx="0">
                  <c:v>5.5433199999999996</c:v>
                </c:pt>
                <c:pt idx="1">
                  <c:v>17.0701</c:v>
                </c:pt>
                <c:pt idx="2">
                  <c:v>6.1977599999999962</c:v>
                </c:pt>
                <c:pt idx="3">
                  <c:v>16.881599999999981</c:v>
                </c:pt>
                <c:pt idx="4">
                  <c:v>6.6439999999999975</c:v>
                </c:pt>
                <c:pt idx="5">
                  <c:v>15.79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226104248"/>
        <c:axId val="261242176"/>
      </c:barChart>
      <c:catAx>
        <c:axId val="226104248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2400000" spcFirstLastPara="1" vertOverflow="ellipsis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261242176"/>
        <c:crosses val="autoZero"/>
        <c:auto val="1"/>
        <c:lblAlgn val="ctr"/>
        <c:lblOffset val="100"/>
        <c:noMultiLvlLbl val="0"/>
      </c:catAx>
      <c:valAx>
        <c:axId val="261242176"/>
        <c:scaling>
          <c:orientation val="minMax"/>
          <c:max val="2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2261042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2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B66F0E7-FD15-4EE7-BE7E-B91504887E14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C5C57E6-2FC1-4B7F-A9C1-B7C3BF2B536F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190647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77C0C4-86BD-44AA-BA48-532F3CE388A5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5560C63-0E5F-4F79-9E19-8EDA44005DCA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474219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47B5FDA-F372-48DD-8C3C-370C9015FCF9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1489A9E-3EB9-4DB6-87D4-E740B71B8816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879980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9C0D9D5-3A67-4F9A-B958-5F084B9A1776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434AF34-1DC5-4FAE-A874-2AFC6626EFCF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328771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1361E0F-CBB6-4295-BEF5-8D6CEFAAD738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164C392-1ABB-401C-9E09-E0F4E77A4BA7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972266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79371B6-4E15-474F-BEF5-8DF1A0CC3F38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27DBF49-C2EE-4243-9DDA-ECACE02EE4FF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165294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8D3B6B8-3310-42C8-9503-82E0DD06A17C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82C61DC-EF6C-42CF-A95F-5EA824D88A58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368266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EE2FFB8-10C3-4DDC-BFB1-F5DA96EF200B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B3A4582-A24B-43AE-8848-B28F27B1CA3D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948640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51840C8-D884-4585-AE4B-8A84B5199728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117750D-E422-4FA2-8A8E-9F144631D8F0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078247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DEA246-8415-4F73-B506-4EF236446FBB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79242D4-7F37-4765-8228-AFFD464C80CC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034320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rtlCol="0">
            <a:normAutofit/>
          </a:bodyPr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lvl="0"/>
            <a:r>
              <a:rPr lang="ko-KR" altLang="en-US" noProof="0" smtClean="0"/>
              <a:t>그림을 추가하려면 아이콘을 클릭하십시오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0A1402F-2B5F-41A6-A9E1-308A4E1683E7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3AACC69-91FE-4395-AD7C-3667926C0548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159488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71488" y="527050"/>
            <a:ext cx="5915025" cy="1914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smtClean="0"/>
              <a:t>마스터 제목 스타일 편집</a:t>
            </a:r>
            <a:endParaRPr lang="en-US" altLang="ko-KR" smtClean="0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71488" y="2636838"/>
            <a:ext cx="5915025" cy="62849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altLang="ko-KR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2100"/>
            <a:ext cx="154305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kumimoji="0" sz="9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BE52F96B-E043-4EF3-850C-A79CC90021C4}" type="datetimeFigureOut">
              <a:rPr lang="ko-KR" altLang="en-US"/>
              <a:pPr>
                <a:defRPr/>
              </a:pPr>
              <a:t>2016-01-3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2100"/>
            <a:ext cx="2314575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kumimoji="0" sz="9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2100"/>
            <a:ext cx="1543050" cy="527050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kumimoji="0" sz="900">
                <a:solidFill>
                  <a:srgbClr val="898989"/>
                </a:solidFill>
                <a:latin typeface="Calibri" panose="020F0502020204030204" pitchFamily="34" charset="0"/>
                <a:ea typeface="맑은 고딕" panose="020B0503020000020004" pitchFamily="50" charset="-127"/>
              </a:defRPr>
            </a:lvl1pPr>
          </a:lstStyle>
          <a:p>
            <a:fld id="{C31CD9A6-5F9B-407A-AD78-81B512AE21E6}" type="slidenum">
              <a:rPr lang="ko-KR" altLang="en-US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  <a:lvl2pPr algn="l" defTabSz="685800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  <a:ea typeface="맑은 고딕" pitchFamily="50" charset="-127"/>
        </a:defRPr>
      </a:lvl2pPr>
      <a:lvl3pPr algn="l" defTabSz="685800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  <a:ea typeface="맑은 고딕" pitchFamily="50" charset="-127"/>
        </a:defRPr>
      </a:lvl3pPr>
      <a:lvl4pPr algn="l" defTabSz="685800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  <a:ea typeface="맑은 고딕" pitchFamily="50" charset="-127"/>
        </a:defRPr>
      </a:lvl4pPr>
      <a:lvl5pPr algn="l" defTabSz="685800" rtl="0" eaLnBrk="0" fontAlgn="base" latinLnBrk="1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  <a:ea typeface="맑은 고딕" pitchFamily="50" charset="-127"/>
        </a:defRPr>
      </a:lvl5pPr>
      <a:lvl6pPr marL="457200" algn="l" defTabSz="685800" rtl="0" fontAlgn="base" latinLnBrk="1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  <a:ea typeface="맑은 고딕" pitchFamily="50" charset="-127"/>
        </a:defRPr>
      </a:lvl6pPr>
      <a:lvl7pPr marL="914400" algn="l" defTabSz="685800" rtl="0" fontAlgn="base" latinLnBrk="1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  <a:ea typeface="맑은 고딕" pitchFamily="50" charset="-127"/>
        </a:defRPr>
      </a:lvl7pPr>
      <a:lvl8pPr marL="1371600" algn="l" defTabSz="685800" rtl="0" fontAlgn="base" latinLnBrk="1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  <a:ea typeface="맑은 고딕" pitchFamily="50" charset="-127"/>
        </a:defRPr>
      </a:lvl8pPr>
      <a:lvl9pPr marL="1828800" algn="l" defTabSz="685800" rtl="0" fontAlgn="base" latinLnBrk="1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/>
          <a:ea typeface="맑은 고딕" pitchFamily="50" charset="-127"/>
        </a:defRPr>
      </a:lvl9pPr>
    </p:titleStyle>
    <p:bodyStyle>
      <a:lvl1pPr marL="171450" indent="-171450" algn="l" defTabSz="685800" rtl="0" eaLnBrk="0" fontAlgn="base" latinLnBrk="1" hangingPunct="0">
        <a:lnSpc>
          <a:spcPct val="90000"/>
        </a:lnSpc>
        <a:spcBef>
          <a:spcPts val="750"/>
        </a:spcBef>
        <a:spcAft>
          <a:spcPct val="0"/>
        </a:spcAft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0" fontAlgn="base" latinLnBrk="1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0" fontAlgn="base" latinLnBrk="1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0" fontAlgn="base" latinLnBrk="1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0" fontAlgn="base" latinLnBrk="1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wmf"/><Relationship Id="rId3" Type="http://schemas.openxmlformats.org/officeDocument/2006/relationships/chart" Target="../charts/chart1.xml"/><Relationship Id="rId7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Relationship Id="rId9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그룹 7"/>
          <p:cNvGrpSpPr/>
          <p:nvPr/>
        </p:nvGrpSpPr>
        <p:grpSpPr>
          <a:xfrm>
            <a:off x="0" y="134112"/>
            <a:ext cx="6858000" cy="8473440"/>
            <a:chOff x="0" y="134112"/>
            <a:chExt cx="6858000" cy="8473440"/>
          </a:xfrm>
        </p:grpSpPr>
        <p:grpSp>
          <p:nvGrpSpPr>
            <p:cNvPr id="6" name="그룹 5"/>
            <p:cNvGrpSpPr/>
            <p:nvPr/>
          </p:nvGrpSpPr>
          <p:grpSpPr>
            <a:xfrm>
              <a:off x="0" y="134112"/>
              <a:ext cx="6858000" cy="8473440"/>
              <a:chOff x="0" y="134112"/>
              <a:chExt cx="6858000" cy="8473440"/>
            </a:xfrm>
          </p:grpSpPr>
          <p:sp>
            <p:nvSpPr>
              <p:cNvPr id="5" name="직사각형 4"/>
              <p:cNvSpPr/>
              <p:nvPr/>
            </p:nvSpPr>
            <p:spPr>
              <a:xfrm>
                <a:off x="0" y="134112"/>
                <a:ext cx="6858000" cy="8473440"/>
              </a:xfrm>
              <a:prstGeom prst="rect">
                <a:avLst/>
              </a:prstGeom>
              <a:ln>
                <a:noFill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3" name="직사각형 2"/>
              <p:cNvSpPr/>
              <p:nvPr/>
            </p:nvSpPr>
            <p:spPr>
              <a:xfrm>
                <a:off x="97536" y="341376"/>
                <a:ext cx="6669024" cy="8083296"/>
              </a:xfrm>
              <a:prstGeom prst="rect">
                <a:avLst/>
              </a:prstGeom>
              <a:ln>
                <a:noFill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graphicFrame>
            <p:nvGraphicFramePr>
              <p:cNvPr id="31" name="차트 30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63651749"/>
                  </p:ext>
                </p:extLst>
              </p:nvPr>
            </p:nvGraphicFramePr>
            <p:xfrm>
              <a:off x="3652839" y="1555750"/>
              <a:ext cx="2670175" cy="225425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aphicFrame>
            <p:nvGraphicFramePr>
              <p:cNvPr id="28" name="차트 27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074540311"/>
                  </p:ext>
                </p:extLst>
              </p:nvPr>
            </p:nvGraphicFramePr>
            <p:xfrm>
              <a:off x="2239171" y="1435100"/>
              <a:ext cx="1246979" cy="22606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7174" name="TextBox 6"/>
              <p:cNvSpPr txBox="1">
                <a:spLocks noChangeArrowheads="1"/>
              </p:cNvSpPr>
              <p:nvPr/>
            </p:nvSpPr>
            <p:spPr bwMode="auto">
              <a:xfrm>
                <a:off x="457200" y="2132013"/>
                <a:ext cx="447675" cy="2143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9pPr>
              </a:lstStyle>
              <a:p>
                <a:pPr eaLnBrk="1" hangingPunct="1"/>
                <a:r>
                  <a:rPr kumimoji="0" lang="en-US" altLang="ko-KR" sz="800" b="1">
                    <a:latin typeface="Arial" panose="020B0604020202020204" pitchFamily="34" charset="0"/>
                    <a:ea typeface="맑은 고딕" panose="020B0503020000020004" pitchFamily="50" charset="-127"/>
                  </a:rPr>
                  <a:t>CD38</a:t>
                </a:r>
              </a:p>
            </p:txBody>
          </p:sp>
          <p:sp>
            <p:nvSpPr>
              <p:cNvPr id="7175" name="TextBox 7"/>
              <p:cNvSpPr txBox="1">
                <a:spLocks noChangeArrowheads="1"/>
              </p:cNvSpPr>
              <p:nvPr/>
            </p:nvSpPr>
            <p:spPr bwMode="auto">
              <a:xfrm>
                <a:off x="457200" y="2593975"/>
                <a:ext cx="53732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9pPr>
              </a:lstStyle>
              <a:p>
                <a:pPr eaLnBrk="1" hangingPunct="1"/>
                <a:r>
                  <a:rPr kumimoji="0" lang="el-GR" altLang="ko-KR" sz="800" b="1" dirty="0" smtClean="0">
                    <a:latin typeface="Arial" panose="020B0604020202020204" pitchFamily="34" charset="0"/>
                    <a:ea typeface="맑은 고딕" panose="020B0503020000020004" pitchFamily="50" charset="-127"/>
                  </a:rPr>
                  <a:t>β</a:t>
                </a:r>
                <a:r>
                  <a:rPr kumimoji="0" lang="en-US" altLang="ko-KR" sz="800" b="1" dirty="0" smtClean="0">
                    <a:latin typeface="Arial" panose="020B0604020202020204" pitchFamily="34" charset="0"/>
                    <a:ea typeface="맑은 고딕" panose="020B0503020000020004" pitchFamily="50" charset="-127"/>
                  </a:rPr>
                  <a:t>-Actin</a:t>
                </a:r>
                <a:endParaRPr kumimoji="0" lang="en-US" altLang="ko-KR" sz="800" b="1" dirty="0">
                  <a:latin typeface="Arial" panose="020B0604020202020204" pitchFamily="34" charset="0"/>
                  <a:ea typeface="맑은 고딕" panose="020B0503020000020004" pitchFamily="50" charset="-127"/>
                </a:endParaRPr>
              </a:p>
            </p:txBody>
          </p:sp>
          <p:sp>
            <p:nvSpPr>
              <p:cNvPr id="7176" name="TextBox 8"/>
              <p:cNvSpPr txBox="1">
                <a:spLocks noChangeArrowheads="1"/>
              </p:cNvSpPr>
              <p:nvPr/>
            </p:nvSpPr>
            <p:spPr bwMode="auto">
              <a:xfrm>
                <a:off x="927631" y="1674813"/>
                <a:ext cx="678391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9pPr>
              </a:lstStyle>
              <a:p>
                <a:pPr algn="ctr" eaLnBrk="1" hangingPunct="1"/>
                <a:r>
                  <a:rPr kumimoji="0" lang="en-US" altLang="ko-KR" sz="800" b="1" dirty="0" smtClean="0">
                    <a:latin typeface="Arial" panose="020B0604020202020204" pitchFamily="34" charset="0"/>
                    <a:ea typeface="맑은 고딕" panose="020B0503020000020004" pitchFamily="50" charset="-127"/>
                  </a:rPr>
                  <a:t>Scramble </a:t>
                </a:r>
                <a:endParaRPr kumimoji="0" lang="en-US" altLang="ko-KR" sz="800" b="1" dirty="0">
                  <a:latin typeface="Arial" panose="020B0604020202020204" pitchFamily="34" charset="0"/>
                  <a:ea typeface="맑은 고딕" panose="020B0503020000020004" pitchFamily="50" charset="-127"/>
                </a:endParaRPr>
              </a:p>
              <a:p>
                <a:pPr algn="ctr" eaLnBrk="1" hangingPunct="1"/>
                <a:r>
                  <a:rPr kumimoji="0" lang="en-US" altLang="ko-KR" sz="800" b="1" dirty="0">
                    <a:latin typeface="Arial" panose="020B0604020202020204" pitchFamily="34" charset="0"/>
                    <a:ea typeface="맑은 고딕" panose="020B0503020000020004" pitchFamily="50" charset="-127"/>
                  </a:rPr>
                  <a:t>shRNA </a:t>
                </a:r>
              </a:p>
            </p:txBody>
          </p:sp>
          <p:sp>
            <p:nvSpPr>
              <p:cNvPr id="7177" name="TextBox 9"/>
              <p:cNvSpPr txBox="1">
                <a:spLocks noChangeArrowheads="1"/>
              </p:cNvSpPr>
              <p:nvPr/>
            </p:nvSpPr>
            <p:spPr bwMode="auto">
              <a:xfrm>
                <a:off x="1485900" y="1674813"/>
                <a:ext cx="525463" cy="3397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9pPr>
              </a:lstStyle>
              <a:p>
                <a:pPr algn="ctr" eaLnBrk="1" hangingPunct="1"/>
                <a:r>
                  <a:rPr kumimoji="0" lang="en-US" altLang="ko-KR" sz="800" b="1">
                    <a:latin typeface="Arial" panose="020B0604020202020204" pitchFamily="34" charset="0"/>
                    <a:ea typeface="맑은 고딕" panose="020B0503020000020004" pitchFamily="50" charset="-127"/>
                  </a:rPr>
                  <a:t>CD38 </a:t>
                </a:r>
              </a:p>
              <a:p>
                <a:pPr algn="ctr" eaLnBrk="1" hangingPunct="1"/>
                <a:r>
                  <a:rPr kumimoji="0" lang="en-US" altLang="ko-KR" sz="800" b="1">
                    <a:latin typeface="Arial" panose="020B0604020202020204" pitchFamily="34" charset="0"/>
                    <a:ea typeface="맑은 고딕" panose="020B0503020000020004" pitchFamily="50" charset="-127"/>
                  </a:rPr>
                  <a:t>shRNA</a:t>
                </a:r>
              </a:p>
            </p:txBody>
          </p:sp>
          <p:sp>
            <p:nvSpPr>
              <p:cNvPr id="7178" name="TextBox 12"/>
              <p:cNvSpPr txBox="1">
                <a:spLocks noChangeArrowheads="1"/>
              </p:cNvSpPr>
              <p:nvPr/>
            </p:nvSpPr>
            <p:spPr bwMode="auto">
              <a:xfrm rot="16200000">
                <a:off x="1468438" y="2089150"/>
                <a:ext cx="1544637" cy="214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9pPr>
              </a:lstStyle>
              <a:p>
                <a:pPr eaLnBrk="1" hangingPunct="1"/>
                <a:r>
                  <a:rPr kumimoji="0" lang="en-US" altLang="ko-KR" sz="800" dirty="0"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Density (vs Scramble </a:t>
                </a:r>
                <a:r>
                  <a:rPr kumimoji="0" lang="en-US" altLang="ko-KR" sz="800" dirty="0" err="1"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shRNA</a:t>
                </a:r>
                <a:r>
                  <a:rPr kumimoji="0" lang="en-US" altLang="ko-KR" sz="800" dirty="0"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)</a:t>
                </a:r>
                <a:endParaRPr kumimoji="0" lang="ko-KR" altLang="en-US" sz="800" dirty="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endParaRPr>
              </a:p>
            </p:txBody>
          </p:sp>
          <p:sp>
            <p:nvSpPr>
              <p:cNvPr id="7179" name="Rectangle 3007"/>
              <p:cNvSpPr>
                <a:spLocks noChangeArrowheads="1"/>
              </p:cNvSpPr>
              <p:nvPr/>
            </p:nvSpPr>
            <p:spPr bwMode="auto">
              <a:xfrm>
                <a:off x="381000" y="1066800"/>
                <a:ext cx="350838" cy="3683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9pPr>
              </a:lstStyle>
              <a:p>
                <a:pPr eaLnBrk="1" hangingPunct="1"/>
                <a:r>
                  <a:rPr kumimoji="0" lang="en-US" altLang="en-US" dirty="0">
                    <a:latin typeface="Arial" panose="020B0604020202020204" pitchFamily="34" charset="0"/>
                    <a:ea typeface="맑은 고딕" panose="020B0503020000020004" pitchFamily="50" charset="-127"/>
                  </a:rPr>
                  <a:t>A</a:t>
                </a:r>
              </a:p>
            </p:txBody>
          </p:sp>
          <p:sp>
            <p:nvSpPr>
              <p:cNvPr id="7180" name="Rectangle 3007"/>
              <p:cNvSpPr>
                <a:spLocks noChangeArrowheads="1"/>
              </p:cNvSpPr>
              <p:nvPr/>
            </p:nvSpPr>
            <p:spPr bwMode="auto">
              <a:xfrm>
                <a:off x="3544888" y="1096963"/>
                <a:ext cx="339725" cy="3683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9pPr>
              </a:lstStyle>
              <a:p>
                <a:pPr eaLnBrk="1" hangingPunct="1"/>
                <a:r>
                  <a:rPr kumimoji="0" lang="en-US" altLang="en-US">
                    <a:latin typeface="Arial" panose="020B0604020202020204" pitchFamily="34" charset="0"/>
                    <a:ea typeface="맑은 고딕" panose="020B0503020000020004" pitchFamily="50" charset="-127"/>
                  </a:rPr>
                  <a:t>B</a:t>
                </a:r>
              </a:p>
            </p:txBody>
          </p:sp>
          <p:sp>
            <p:nvSpPr>
              <p:cNvPr id="7181" name="TextBox 17"/>
              <p:cNvSpPr txBox="1">
                <a:spLocks noChangeArrowheads="1"/>
              </p:cNvSpPr>
              <p:nvPr/>
            </p:nvSpPr>
            <p:spPr bwMode="auto">
              <a:xfrm>
                <a:off x="3046413" y="2486025"/>
                <a:ext cx="255587" cy="3079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9pPr>
              </a:lstStyle>
              <a:p>
                <a:pPr eaLnBrk="1" hangingPunct="1"/>
                <a:r>
                  <a:rPr kumimoji="0" lang="en-US" altLang="ko-KR" sz="1400">
                    <a:latin typeface="Arial" panose="020B0604020202020204" pitchFamily="34" charset="0"/>
                    <a:ea typeface="맑은 고딕" panose="020B0503020000020004" pitchFamily="50" charset="-127"/>
                  </a:rPr>
                  <a:t>*</a:t>
                </a:r>
                <a:endParaRPr kumimoji="0" lang="ko-KR" altLang="en-US" sz="1400">
                  <a:latin typeface="Arial" panose="020B0604020202020204" pitchFamily="34" charset="0"/>
                  <a:ea typeface="맑은 고딕" panose="020B0503020000020004" pitchFamily="50" charset="-127"/>
                </a:endParaRPr>
              </a:p>
            </p:txBody>
          </p:sp>
          <p:graphicFrame>
            <p:nvGraphicFramePr>
              <p:cNvPr id="19" name="차트 18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539638754"/>
                  </p:ext>
                </p:extLst>
              </p:nvPr>
            </p:nvGraphicFramePr>
            <p:xfrm>
              <a:off x="731839" y="3962400"/>
              <a:ext cx="2717959" cy="23749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sp>
            <p:nvSpPr>
              <p:cNvPr id="7183" name="TextBox 19"/>
              <p:cNvSpPr txBox="1">
                <a:spLocks noChangeArrowheads="1"/>
              </p:cNvSpPr>
              <p:nvPr/>
            </p:nvSpPr>
            <p:spPr bwMode="auto">
              <a:xfrm rot="16200000">
                <a:off x="48419" y="4709319"/>
                <a:ext cx="1252538" cy="2159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9pPr>
              </a:lstStyle>
              <a:p>
                <a:pPr eaLnBrk="1" hangingPunct="1"/>
                <a:r>
                  <a:rPr kumimoji="0" lang="en-US" altLang="ko-KR" sz="800" dirty="0" err="1">
                    <a:latin typeface="Arial" panose="020B0604020202020204" pitchFamily="34" charset="0"/>
                    <a:ea typeface="맑은 고딕" panose="020B0503020000020004" pitchFamily="50" charset="-127"/>
                  </a:rPr>
                  <a:t>cADPR</a:t>
                </a:r>
                <a:r>
                  <a:rPr kumimoji="0" lang="en-US" altLang="ko-KR" sz="800" dirty="0">
                    <a:latin typeface="Arial" panose="020B0604020202020204" pitchFamily="34" charset="0"/>
                    <a:ea typeface="맑은 고딕" panose="020B0503020000020004" pitchFamily="50" charset="-127"/>
                  </a:rPr>
                  <a:t> level (</a:t>
                </a:r>
                <a:r>
                  <a:rPr kumimoji="0" lang="en-US" altLang="ko-KR" sz="800" dirty="0" err="1">
                    <a:latin typeface="Arial" panose="020B0604020202020204" pitchFamily="34" charset="0"/>
                    <a:ea typeface="맑은 고딕" panose="020B0503020000020004" pitchFamily="50" charset="-127"/>
                  </a:rPr>
                  <a:t>pmol</a:t>
                </a:r>
                <a:r>
                  <a:rPr kumimoji="0" lang="en-US" altLang="ko-KR" sz="800" dirty="0">
                    <a:latin typeface="Arial" panose="020B0604020202020204" pitchFamily="34" charset="0"/>
                    <a:ea typeface="맑은 고딕" panose="020B0503020000020004" pitchFamily="50" charset="-127"/>
                  </a:rPr>
                  <a:t>/mg)</a:t>
                </a:r>
                <a:endParaRPr kumimoji="0" lang="ko-KR" altLang="en-US" sz="800" dirty="0">
                  <a:latin typeface="Arial" panose="020B0604020202020204" pitchFamily="34" charset="0"/>
                  <a:ea typeface="맑은 고딕" panose="020B0503020000020004" pitchFamily="50" charset="-127"/>
                </a:endParaRPr>
              </a:p>
            </p:txBody>
          </p:sp>
          <p:sp>
            <p:nvSpPr>
              <p:cNvPr id="7184" name="Rectangle 3007"/>
              <p:cNvSpPr>
                <a:spLocks noChangeArrowheads="1"/>
              </p:cNvSpPr>
              <p:nvPr/>
            </p:nvSpPr>
            <p:spPr bwMode="auto">
              <a:xfrm>
                <a:off x="381000" y="3560763"/>
                <a:ext cx="350838" cy="3683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9pPr>
              </a:lstStyle>
              <a:p>
                <a:pPr eaLnBrk="1" hangingPunct="1"/>
                <a:r>
                  <a:rPr kumimoji="0" lang="en-US" altLang="en-US">
                    <a:latin typeface="Arial" panose="020B0604020202020204" pitchFamily="34" charset="0"/>
                    <a:ea typeface="맑은 고딕" panose="020B0503020000020004" pitchFamily="50" charset="-127"/>
                  </a:rPr>
                  <a:t>C</a:t>
                </a:r>
              </a:p>
            </p:txBody>
          </p:sp>
          <p:sp>
            <p:nvSpPr>
              <p:cNvPr id="7185" name="TextBox 22"/>
              <p:cNvSpPr txBox="1">
                <a:spLocks noChangeArrowheads="1"/>
              </p:cNvSpPr>
              <p:nvPr/>
            </p:nvSpPr>
            <p:spPr bwMode="auto">
              <a:xfrm rot="16200000">
                <a:off x="2961482" y="4718843"/>
                <a:ext cx="1270000" cy="214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9pPr>
              </a:lstStyle>
              <a:p>
                <a:pPr eaLnBrk="1" hangingPunct="1"/>
                <a:r>
                  <a:rPr kumimoji="0" lang="en-US" altLang="ko-KR" sz="800">
                    <a:latin typeface="Arial" panose="020B0604020202020204" pitchFamily="34" charset="0"/>
                    <a:ea typeface="맑은 고딕" panose="020B0503020000020004" pitchFamily="50" charset="-127"/>
                  </a:rPr>
                  <a:t>NAADP level (pmol/mg)</a:t>
                </a:r>
                <a:endParaRPr kumimoji="0" lang="ko-KR" altLang="en-US" sz="800">
                  <a:latin typeface="Arial" panose="020B0604020202020204" pitchFamily="34" charset="0"/>
                  <a:ea typeface="맑은 고딕" panose="020B0503020000020004" pitchFamily="50" charset="-127"/>
                </a:endParaRPr>
              </a:p>
            </p:txBody>
          </p:sp>
          <p:sp>
            <p:nvSpPr>
              <p:cNvPr id="7186" name="Rectangle 3007"/>
              <p:cNvSpPr>
                <a:spLocks noChangeArrowheads="1"/>
              </p:cNvSpPr>
              <p:nvPr/>
            </p:nvSpPr>
            <p:spPr bwMode="auto">
              <a:xfrm>
                <a:off x="3397250" y="3560763"/>
                <a:ext cx="352425" cy="3683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9pPr>
              </a:lstStyle>
              <a:p>
                <a:pPr eaLnBrk="1" hangingPunct="1"/>
                <a:r>
                  <a:rPr kumimoji="0" lang="en-US" altLang="en-US">
                    <a:latin typeface="Arial" panose="020B0604020202020204" pitchFamily="34" charset="0"/>
                    <a:ea typeface="맑은 고딕" panose="020B0503020000020004" pitchFamily="50" charset="-127"/>
                  </a:rPr>
                  <a:t>D</a:t>
                </a:r>
              </a:p>
            </p:txBody>
          </p:sp>
          <p:graphicFrame>
            <p:nvGraphicFramePr>
              <p:cNvPr id="26" name="차트 25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4108545223"/>
                  </p:ext>
                </p:extLst>
              </p:nvPr>
            </p:nvGraphicFramePr>
            <p:xfrm>
              <a:off x="3653405" y="3981450"/>
              <a:ext cx="2715645" cy="23495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sp>
            <p:nvSpPr>
              <p:cNvPr id="7188" name="TextBox 28"/>
              <p:cNvSpPr txBox="1">
                <a:spLocks noChangeArrowheads="1"/>
              </p:cNvSpPr>
              <p:nvPr/>
            </p:nvSpPr>
            <p:spPr bwMode="auto">
              <a:xfrm>
                <a:off x="1450975" y="4184650"/>
                <a:ext cx="265113" cy="3381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9pPr>
              </a:lstStyle>
              <a:p>
                <a:pPr eaLnBrk="1" hangingPunct="1"/>
                <a:r>
                  <a:rPr kumimoji="0" lang="en-US" altLang="ko-KR" sz="1600">
                    <a:latin typeface="Arial" panose="020B0604020202020204" pitchFamily="34" charset="0"/>
                    <a:ea typeface="맑은 고딕" panose="020B0503020000020004" pitchFamily="50" charset="-127"/>
                  </a:rPr>
                  <a:t>*</a:t>
                </a:r>
                <a:endParaRPr kumimoji="0" lang="ko-KR" altLang="en-US" sz="1600">
                  <a:latin typeface="Arial" panose="020B0604020202020204" pitchFamily="34" charset="0"/>
                  <a:ea typeface="맑은 고딕" panose="020B0503020000020004" pitchFamily="50" charset="-127"/>
                </a:endParaRPr>
              </a:p>
            </p:txBody>
          </p:sp>
          <p:sp>
            <p:nvSpPr>
              <p:cNvPr id="7189" name="TextBox 29"/>
              <p:cNvSpPr txBox="1">
                <a:spLocks noChangeArrowheads="1"/>
              </p:cNvSpPr>
              <p:nvPr/>
            </p:nvSpPr>
            <p:spPr bwMode="auto">
              <a:xfrm>
                <a:off x="1841500" y="5043488"/>
                <a:ext cx="263525" cy="2619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9pPr>
              </a:lstStyle>
              <a:p>
                <a:pPr eaLnBrk="1" hangingPunct="1"/>
                <a:r>
                  <a:rPr kumimoji="0" lang="en-US" altLang="ko-KR" sz="1100">
                    <a:latin typeface="Arial" panose="020B0604020202020204" pitchFamily="34" charset="0"/>
                    <a:ea typeface="맑은 고딕" panose="020B0503020000020004" pitchFamily="50" charset="-127"/>
                  </a:rPr>
                  <a:t>#</a:t>
                </a:r>
                <a:endParaRPr kumimoji="0" lang="ko-KR" altLang="en-US" sz="1100">
                  <a:latin typeface="Arial" panose="020B0604020202020204" pitchFamily="34" charset="0"/>
                  <a:ea typeface="맑은 고딕" panose="020B0503020000020004" pitchFamily="50" charset="-127"/>
                </a:endParaRPr>
              </a:p>
            </p:txBody>
          </p:sp>
          <p:sp>
            <p:nvSpPr>
              <p:cNvPr id="7190" name="TextBox 30"/>
              <p:cNvSpPr txBox="1">
                <a:spLocks noChangeArrowheads="1"/>
              </p:cNvSpPr>
              <p:nvPr/>
            </p:nvSpPr>
            <p:spPr bwMode="auto">
              <a:xfrm>
                <a:off x="2603500" y="5068888"/>
                <a:ext cx="263525" cy="2619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9pPr>
              </a:lstStyle>
              <a:p>
                <a:pPr eaLnBrk="1" hangingPunct="1"/>
                <a:r>
                  <a:rPr kumimoji="0" lang="en-US" altLang="ko-KR" sz="1100">
                    <a:latin typeface="Arial" panose="020B0604020202020204" pitchFamily="34" charset="0"/>
                    <a:ea typeface="맑은 고딕" panose="020B0503020000020004" pitchFamily="50" charset="-127"/>
                  </a:rPr>
                  <a:t>#</a:t>
                </a:r>
                <a:endParaRPr kumimoji="0" lang="ko-KR" altLang="en-US" sz="1100">
                  <a:latin typeface="Arial" panose="020B0604020202020204" pitchFamily="34" charset="0"/>
                  <a:ea typeface="맑은 고딕" panose="020B0503020000020004" pitchFamily="50" charset="-127"/>
                </a:endParaRPr>
              </a:p>
            </p:txBody>
          </p:sp>
          <p:sp>
            <p:nvSpPr>
              <p:cNvPr id="7191" name="TextBox 31"/>
              <p:cNvSpPr txBox="1">
                <a:spLocks noChangeArrowheads="1"/>
              </p:cNvSpPr>
              <p:nvPr/>
            </p:nvSpPr>
            <p:spPr bwMode="auto">
              <a:xfrm>
                <a:off x="2990850" y="5062538"/>
                <a:ext cx="263525" cy="2619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9pPr>
              </a:lstStyle>
              <a:p>
                <a:pPr eaLnBrk="1" hangingPunct="1"/>
                <a:r>
                  <a:rPr kumimoji="0" lang="en-US" altLang="ko-KR" sz="1100">
                    <a:latin typeface="Arial" panose="020B0604020202020204" pitchFamily="34" charset="0"/>
                    <a:ea typeface="맑은 고딕" panose="020B0503020000020004" pitchFamily="50" charset="-127"/>
                  </a:rPr>
                  <a:t>#</a:t>
                </a:r>
                <a:endParaRPr kumimoji="0" lang="ko-KR" altLang="en-US" sz="1100">
                  <a:latin typeface="Arial" panose="020B0604020202020204" pitchFamily="34" charset="0"/>
                  <a:ea typeface="맑은 고딕" panose="020B0503020000020004" pitchFamily="50" charset="-127"/>
                </a:endParaRPr>
              </a:p>
            </p:txBody>
          </p:sp>
          <p:sp>
            <p:nvSpPr>
              <p:cNvPr id="7192" name="TextBox 32"/>
              <p:cNvSpPr txBox="1">
                <a:spLocks noChangeArrowheads="1"/>
              </p:cNvSpPr>
              <p:nvPr/>
            </p:nvSpPr>
            <p:spPr bwMode="auto">
              <a:xfrm>
                <a:off x="4760913" y="4862513"/>
                <a:ext cx="263525" cy="2619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9pPr>
              </a:lstStyle>
              <a:p>
                <a:pPr eaLnBrk="1" hangingPunct="1"/>
                <a:r>
                  <a:rPr kumimoji="0" lang="en-US" altLang="ko-KR" sz="1100">
                    <a:latin typeface="Arial" panose="020B0604020202020204" pitchFamily="34" charset="0"/>
                    <a:ea typeface="맑은 고딕" panose="020B0503020000020004" pitchFamily="50" charset="-127"/>
                  </a:rPr>
                  <a:t>#</a:t>
                </a:r>
                <a:endParaRPr kumimoji="0" lang="ko-KR" altLang="en-US" sz="1100">
                  <a:latin typeface="Arial" panose="020B0604020202020204" pitchFamily="34" charset="0"/>
                  <a:ea typeface="맑은 고딕" panose="020B0503020000020004" pitchFamily="50" charset="-127"/>
                </a:endParaRPr>
              </a:p>
            </p:txBody>
          </p:sp>
          <p:sp>
            <p:nvSpPr>
              <p:cNvPr id="7193" name="TextBox 33"/>
              <p:cNvSpPr txBox="1">
                <a:spLocks noChangeArrowheads="1"/>
              </p:cNvSpPr>
              <p:nvPr/>
            </p:nvSpPr>
            <p:spPr bwMode="auto">
              <a:xfrm>
                <a:off x="5522913" y="4811713"/>
                <a:ext cx="263525" cy="2619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9pPr>
              </a:lstStyle>
              <a:p>
                <a:pPr eaLnBrk="1" hangingPunct="1"/>
                <a:r>
                  <a:rPr kumimoji="0" lang="en-US" altLang="ko-KR" sz="1100">
                    <a:latin typeface="Arial" panose="020B0604020202020204" pitchFamily="34" charset="0"/>
                    <a:ea typeface="맑은 고딕" panose="020B0503020000020004" pitchFamily="50" charset="-127"/>
                  </a:rPr>
                  <a:t>#</a:t>
                </a:r>
                <a:endParaRPr kumimoji="0" lang="ko-KR" altLang="en-US" sz="1100">
                  <a:latin typeface="Arial" panose="020B0604020202020204" pitchFamily="34" charset="0"/>
                  <a:ea typeface="맑은 고딕" panose="020B0503020000020004" pitchFamily="50" charset="-127"/>
                </a:endParaRPr>
              </a:p>
            </p:txBody>
          </p:sp>
          <p:sp>
            <p:nvSpPr>
              <p:cNvPr id="7194" name="TextBox 34"/>
              <p:cNvSpPr txBox="1">
                <a:spLocks noChangeArrowheads="1"/>
              </p:cNvSpPr>
              <p:nvPr/>
            </p:nvSpPr>
            <p:spPr bwMode="auto">
              <a:xfrm>
                <a:off x="4378325" y="4267200"/>
                <a:ext cx="265113" cy="3381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9pPr>
              </a:lstStyle>
              <a:p>
                <a:pPr eaLnBrk="1" hangingPunct="1"/>
                <a:r>
                  <a:rPr kumimoji="0" lang="en-US" altLang="ko-KR" sz="1600">
                    <a:latin typeface="Arial" panose="020B0604020202020204" pitchFamily="34" charset="0"/>
                    <a:ea typeface="맑은 고딕" panose="020B0503020000020004" pitchFamily="50" charset="-127"/>
                  </a:rPr>
                  <a:t>*</a:t>
                </a:r>
                <a:endParaRPr kumimoji="0" lang="ko-KR" altLang="en-US" sz="1600">
                  <a:latin typeface="Arial" panose="020B0604020202020204" pitchFamily="34" charset="0"/>
                  <a:ea typeface="맑은 고딕" panose="020B0503020000020004" pitchFamily="50" charset="-127"/>
                </a:endParaRPr>
              </a:p>
            </p:txBody>
          </p:sp>
          <p:sp>
            <p:nvSpPr>
              <p:cNvPr id="7196" name="TextBox 38"/>
              <p:cNvSpPr txBox="1">
                <a:spLocks noChangeArrowheads="1"/>
              </p:cNvSpPr>
              <p:nvPr/>
            </p:nvSpPr>
            <p:spPr bwMode="auto">
              <a:xfrm>
                <a:off x="3910013" y="2476500"/>
                <a:ext cx="361950" cy="2159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9pPr>
              </a:lstStyle>
              <a:p>
                <a:pPr eaLnBrk="1" hangingPunct="1"/>
                <a:r>
                  <a:rPr kumimoji="0" lang="en-US" altLang="ko-KR" sz="800" dirty="0">
                    <a:latin typeface="Arial" panose="020B0604020202020204" pitchFamily="34" charset="0"/>
                    <a:ea typeface="맑은 고딕" panose="020B0503020000020004" pitchFamily="50" charset="-127"/>
                  </a:rPr>
                  <a:t>ISO</a:t>
                </a:r>
                <a:endParaRPr kumimoji="0" lang="ko-KR" altLang="en-US" sz="800" dirty="0">
                  <a:latin typeface="Arial" panose="020B0604020202020204" pitchFamily="34" charset="0"/>
                  <a:ea typeface="맑은 고딕" panose="020B0503020000020004" pitchFamily="50" charset="-127"/>
                </a:endParaRPr>
              </a:p>
            </p:txBody>
          </p:sp>
          <p:cxnSp>
            <p:nvCxnSpPr>
              <p:cNvPr id="40" name="직선 화살표 연결선 39"/>
              <p:cNvCxnSpPr/>
              <p:nvPr/>
            </p:nvCxnSpPr>
            <p:spPr>
              <a:xfrm>
                <a:off x="4129088" y="2647950"/>
                <a:ext cx="0" cy="211138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0" name="TextBox 29"/>
              <p:cNvSpPr txBox="1">
                <a:spLocks noChangeArrowheads="1"/>
              </p:cNvSpPr>
              <p:nvPr/>
            </p:nvSpPr>
            <p:spPr bwMode="auto">
              <a:xfrm rot="16200000">
                <a:off x="3255590" y="2295380"/>
                <a:ext cx="700833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9pPr>
              </a:lstStyle>
              <a:p>
                <a:pPr algn="ctr" eaLnBrk="1" hangingPunct="1"/>
                <a:r>
                  <a:rPr kumimoji="0" lang="en-US" altLang="en-US" sz="800" dirty="0">
                    <a:latin typeface="Arial" panose="020B0604020202020204" pitchFamily="34" charset="0"/>
                    <a:ea typeface="맑은 고딕" panose="020B0503020000020004" pitchFamily="50" charset="-127"/>
                  </a:rPr>
                  <a:t>[Ca</a:t>
                </a:r>
                <a:r>
                  <a:rPr kumimoji="0" lang="en-US" altLang="en-US" sz="800" baseline="30000" dirty="0">
                    <a:latin typeface="Arial" panose="020B0604020202020204" pitchFamily="34" charset="0"/>
                    <a:ea typeface="맑은 고딕" panose="020B0503020000020004" pitchFamily="50" charset="-127"/>
                  </a:rPr>
                  <a:t>2+</a:t>
                </a:r>
                <a:r>
                  <a:rPr kumimoji="0" lang="en-US" altLang="en-US" sz="800" dirty="0">
                    <a:latin typeface="Arial" panose="020B0604020202020204" pitchFamily="34" charset="0"/>
                    <a:ea typeface="맑은 고딕" panose="020B0503020000020004" pitchFamily="50" charset="-127"/>
                  </a:rPr>
                  <a:t>]</a:t>
                </a:r>
                <a:r>
                  <a:rPr kumimoji="0" lang="en-US" altLang="en-US" sz="800" baseline="-25000" dirty="0">
                    <a:latin typeface="Arial" panose="020B0604020202020204" pitchFamily="34" charset="0"/>
                    <a:ea typeface="맑은 고딕" panose="020B0503020000020004" pitchFamily="50" charset="-127"/>
                  </a:rPr>
                  <a:t>I </a:t>
                </a:r>
                <a:r>
                  <a:rPr kumimoji="0" lang="en-US" altLang="en-US" sz="800" dirty="0">
                    <a:latin typeface="Arial" panose="020B0604020202020204" pitchFamily="34" charset="0"/>
                    <a:ea typeface="맑은 고딕" panose="020B0503020000020004" pitchFamily="50" charset="-127"/>
                  </a:rPr>
                  <a:t>(</a:t>
                </a:r>
                <a:r>
                  <a:rPr kumimoji="0" lang="en-US" altLang="en-US" sz="800" dirty="0" err="1" smtClean="0">
                    <a:latin typeface="Arial" panose="020B0604020202020204" pitchFamily="34" charset="0"/>
                    <a:ea typeface="맑은 고딕" panose="020B0503020000020004" pitchFamily="50" charset="-127"/>
                  </a:rPr>
                  <a:t>nM</a:t>
                </a:r>
                <a:r>
                  <a:rPr kumimoji="0" lang="en-US" altLang="en-US" sz="800" dirty="0" smtClean="0">
                    <a:latin typeface="Arial" panose="020B0604020202020204" pitchFamily="34" charset="0"/>
                    <a:ea typeface="맑은 고딕" panose="020B0503020000020004" pitchFamily="50" charset="-127"/>
                  </a:rPr>
                  <a:t>)</a:t>
                </a:r>
                <a:endParaRPr kumimoji="0" lang="en-US" altLang="en-US" sz="800" dirty="0">
                  <a:latin typeface="Arial" panose="020B0604020202020204" pitchFamily="34" charset="0"/>
                  <a:ea typeface="맑은 고딕" panose="020B0503020000020004" pitchFamily="50" charset="-127"/>
                </a:endParaRPr>
              </a:p>
            </p:txBody>
          </p:sp>
          <p:sp>
            <p:nvSpPr>
              <p:cNvPr id="32" name="TextBox 21"/>
              <p:cNvSpPr txBox="1">
                <a:spLocks noChangeArrowheads="1"/>
              </p:cNvSpPr>
              <p:nvPr/>
            </p:nvSpPr>
            <p:spPr bwMode="auto">
              <a:xfrm>
                <a:off x="4837113" y="3459392"/>
                <a:ext cx="530920" cy="2154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panose="020B0600000101010101" pitchFamily="50" charset="-127"/>
                    <a:ea typeface="굴림" panose="020B0600000101010101" pitchFamily="50" charset="-127"/>
                  </a:defRPr>
                </a:lvl9pPr>
              </a:lstStyle>
              <a:p>
                <a:pPr eaLnBrk="1" hangingPunct="1"/>
                <a:r>
                  <a:rPr kumimoji="0" lang="en-US" altLang="ko-KR" sz="800">
                    <a:latin typeface="Arial" panose="020B0604020202020204" pitchFamily="34" charset="0"/>
                    <a:ea typeface="맑은 고딕" panose="020B0503020000020004" pitchFamily="50" charset="-127"/>
                  </a:rPr>
                  <a:t>Time(s)</a:t>
                </a:r>
                <a:endParaRPr kumimoji="0" lang="ko-KR" altLang="en-US" sz="800">
                  <a:latin typeface="Arial" panose="020B0604020202020204" pitchFamily="34" charset="0"/>
                  <a:ea typeface="맑은 고딕" panose="020B0503020000020004" pitchFamily="50" charset="-127"/>
                </a:endParaRPr>
              </a:p>
            </p:txBody>
          </p:sp>
          <p:sp>
            <p:nvSpPr>
              <p:cNvPr id="2" name="직사각형 1"/>
              <p:cNvSpPr/>
              <p:nvPr/>
            </p:nvSpPr>
            <p:spPr>
              <a:xfrm>
                <a:off x="457200" y="6607303"/>
                <a:ext cx="5858256" cy="144655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just">
                  <a:spcAft>
                    <a:spcPts val="0"/>
                  </a:spcAft>
                </a:pPr>
                <a:r>
                  <a:rPr lang="en-US" altLang="ko-KR" sz="1100" b="1" kern="100" dirty="0" smtClean="0">
                    <a:latin typeface="Times New Roman" panose="02020603050405020304" pitchFamily="18" charset="0"/>
                    <a:ea typeface="바탕체" panose="02030609000101010101" pitchFamily="17" charset="-127"/>
                  </a:rPr>
                  <a:t>S1 Fig. </a:t>
                </a:r>
                <a:r>
                  <a:rPr lang="en-US" altLang="ko-KR" sz="1100" b="1" kern="100" dirty="0">
                    <a:latin typeface="Times New Roman" panose="02020603050405020304" pitchFamily="18" charset="0"/>
                    <a:ea typeface="바탕체" panose="02030609000101010101" pitchFamily="17" charset="-127"/>
                  </a:rPr>
                  <a:t>ISO-mediated </a:t>
                </a:r>
                <a:r>
                  <a:rPr lang="en-US" altLang="ko-KR" sz="1100" b="1" kern="100" dirty="0">
                    <a:latin typeface="Times New Roman" panose="02020603050405020304" pitchFamily="18" charset="0"/>
                  </a:rPr>
                  <a:t>Ca</a:t>
                </a:r>
                <a:r>
                  <a:rPr lang="en-US" altLang="ko-KR" sz="1100" b="1" kern="100" baseline="30000" dirty="0">
                    <a:latin typeface="Times New Roman" panose="02020603050405020304" pitchFamily="18" charset="0"/>
                  </a:rPr>
                  <a:t>2+</a:t>
                </a:r>
                <a:r>
                  <a:rPr lang="en-US" altLang="ko-KR" sz="1100" b="1" kern="100" dirty="0">
                    <a:latin typeface="Times New Roman" panose="02020603050405020304" pitchFamily="18" charset="0"/>
                  </a:rPr>
                  <a:t> increase and </a:t>
                </a:r>
                <a:r>
                  <a:rPr lang="en-US" altLang="ko-KR" sz="1100" b="1" kern="100" dirty="0" err="1">
                    <a:latin typeface="Times New Roman" panose="02020603050405020304" pitchFamily="18" charset="0"/>
                  </a:rPr>
                  <a:t>cADPR</a:t>
                </a:r>
                <a:r>
                  <a:rPr lang="en-US" altLang="ko-KR" sz="1100" b="1" kern="100" dirty="0">
                    <a:latin typeface="Times New Roman" panose="02020603050405020304" pitchFamily="18" charset="0"/>
                  </a:rPr>
                  <a:t>/NAADP production were abolished by </a:t>
                </a:r>
                <a:r>
                  <a:rPr lang="en-US" altLang="ko-KR" sz="1100" b="1" kern="100" dirty="0">
                    <a:latin typeface="Times New Roman" panose="02020603050405020304" pitchFamily="18" charset="0"/>
                    <a:ea typeface="바탕체" panose="02030609000101010101" pitchFamily="17" charset="-127"/>
                  </a:rPr>
                  <a:t>downregulation of CD38</a:t>
                </a:r>
                <a:r>
                  <a:rPr lang="en-US" altLang="ko-KR" sz="1100" kern="100" dirty="0">
                    <a:latin typeface="Times New Roman" panose="02020603050405020304" pitchFamily="18" charset="0"/>
                    <a:ea typeface="바탕체" panose="02030609000101010101" pitchFamily="17" charset="-127"/>
                  </a:rPr>
                  <a:t> </a:t>
                </a:r>
                <a:r>
                  <a:rPr lang="en-US" altLang="ko-KR" sz="1100" b="1" kern="100" dirty="0">
                    <a:latin typeface="Times New Roman" panose="02020603050405020304" pitchFamily="18" charset="0"/>
                    <a:ea typeface="바탕체" panose="02030609000101010101" pitchFamily="17" charset="-127"/>
                  </a:rPr>
                  <a:t>gene expression with shRNA. (A)</a:t>
                </a:r>
                <a:r>
                  <a:rPr lang="en-US" altLang="ko-KR" sz="1100" kern="100" dirty="0">
                    <a:latin typeface="Times New Roman" panose="02020603050405020304" pitchFamily="18" charset="0"/>
                    <a:ea typeface="바탕체" panose="02030609000101010101" pitchFamily="17" charset="-127"/>
                  </a:rPr>
                  <a:t> Representative </a:t>
                </a:r>
                <a:r>
                  <a:rPr lang="en-US" altLang="ko-KR" sz="1100" kern="100" dirty="0" err="1">
                    <a:latin typeface="Times New Roman" panose="02020603050405020304" pitchFamily="18" charset="0"/>
                    <a:ea typeface="바탕체" panose="02030609000101010101" pitchFamily="17" charset="-127"/>
                  </a:rPr>
                  <a:t>immunoblots</a:t>
                </a:r>
                <a:r>
                  <a:rPr lang="en-US" altLang="ko-KR" sz="1100" kern="100" dirty="0">
                    <a:latin typeface="Times New Roman" panose="02020603050405020304" pitchFamily="18" charset="0"/>
                    <a:ea typeface="바탕체" panose="02030609000101010101" pitchFamily="17" charset="-127"/>
                  </a:rPr>
                  <a:t> with summary quantifications of CD38 protein expression in </a:t>
                </a:r>
                <a:r>
                  <a:rPr lang="en-US" altLang="ko-KR" sz="1100" kern="100" dirty="0" err="1">
                    <a:latin typeface="Times New Roman" panose="02020603050405020304" pitchFamily="18" charset="0"/>
                    <a:ea typeface="바탕체" panose="02030609000101010101" pitchFamily="17" charset="-127"/>
                  </a:rPr>
                  <a:t>cardiomyocytes</a:t>
                </a:r>
                <a:r>
                  <a:rPr lang="en-US" altLang="ko-KR" sz="1100" kern="100" dirty="0">
                    <a:latin typeface="Times New Roman" panose="02020603050405020304" pitchFamily="18" charset="0"/>
                    <a:ea typeface="바탕체" panose="02030609000101010101" pitchFamily="17" charset="-127"/>
                  </a:rPr>
                  <a:t> after infection with </a:t>
                </a:r>
                <a:r>
                  <a:rPr lang="en-US" altLang="ko-KR" sz="1100" kern="100" dirty="0" err="1">
                    <a:latin typeface="Times New Roman" panose="02020603050405020304" pitchFamily="18" charset="0"/>
                    <a:ea typeface="바탕체" panose="02030609000101010101" pitchFamily="17" charset="-127"/>
                  </a:rPr>
                  <a:t>lentiviral</a:t>
                </a:r>
                <a:r>
                  <a:rPr lang="en-US" altLang="ko-KR" sz="1100" kern="100" dirty="0">
                    <a:latin typeface="Times New Roman" panose="02020603050405020304" pitchFamily="18" charset="0"/>
                    <a:ea typeface="바탕체" panose="02030609000101010101" pitchFamily="17" charset="-127"/>
                  </a:rPr>
                  <a:t> particles expressing scrambled or CD38-specific short hairpin (</a:t>
                </a:r>
                <a:r>
                  <a:rPr lang="en-US" altLang="ko-KR" sz="1100" kern="100" dirty="0" err="1">
                    <a:latin typeface="Times New Roman" panose="02020603050405020304" pitchFamily="18" charset="0"/>
                    <a:ea typeface="바탕체" panose="02030609000101010101" pitchFamily="17" charset="-127"/>
                  </a:rPr>
                  <a:t>shRNA</a:t>
                </a:r>
                <a:r>
                  <a:rPr lang="en-US" altLang="ko-KR" sz="1100" kern="100" dirty="0">
                    <a:latin typeface="Times New Roman" panose="02020603050405020304" pitchFamily="18" charset="0"/>
                    <a:ea typeface="바탕체" panose="02030609000101010101" pitchFamily="17" charset="-127"/>
                  </a:rPr>
                  <a:t>). </a:t>
                </a:r>
                <a:r>
                  <a:rPr lang="en-US" altLang="ko-KR" sz="1100" b="1" kern="100" dirty="0">
                    <a:latin typeface="Times New Roman" panose="02020603050405020304" pitchFamily="18" charset="0"/>
                    <a:ea typeface="바탕체" panose="02030609000101010101" pitchFamily="17" charset="-127"/>
                  </a:rPr>
                  <a:t>(B)</a:t>
                </a:r>
                <a:r>
                  <a:rPr lang="en-US" altLang="ko-KR" sz="1100" kern="100" dirty="0">
                    <a:latin typeface="Times New Roman" panose="02020603050405020304" pitchFamily="18" charset="0"/>
                    <a:ea typeface="바탕체" panose="02030609000101010101" pitchFamily="17" charset="-127"/>
                  </a:rPr>
                  <a:t> Representative tracings of the </a:t>
                </a:r>
                <a:r>
                  <a:rPr lang="en-US" altLang="ko-KR" sz="1100" kern="100" dirty="0">
                    <a:latin typeface="Times New Roman" panose="02020603050405020304" pitchFamily="18" charset="0"/>
                  </a:rPr>
                  <a:t>Ca</a:t>
                </a:r>
                <a:r>
                  <a:rPr lang="en-US" altLang="ko-KR" sz="1100" kern="100" baseline="30000" dirty="0">
                    <a:latin typeface="Times New Roman" panose="02020603050405020304" pitchFamily="18" charset="0"/>
                  </a:rPr>
                  <a:t>2+</a:t>
                </a:r>
                <a:r>
                  <a:rPr lang="en-US" altLang="ko-KR" sz="1100" kern="100" dirty="0">
                    <a:latin typeface="Times New Roman" panose="02020603050405020304" pitchFamily="18" charset="0"/>
                  </a:rPr>
                  <a:t> response to ISO in </a:t>
                </a:r>
                <a:r>
                  <a:rPr lang="en-US" altLang="ko-KR" sz="1100" kern="100" dirty="0" err="1">
                    <a:latin typeface="Times New Roman" panose="02020603050405020304" pitchFamily="18" charset="0"/>
                  </a:rPr>
                  <a:t>cardiomyocytes</a:t>
                </a:r>
                <a:r>
                  <a:rPr lang="en-US" altLang="ko-KR" sz="1100" kern="100" dirty="0">
                    <a:latin typeface="Times New Roman" panose="02020603050405020304" pitchFamily="18" charset="0"/>
                  </a:rPr>
                  <a:t> infected with scrambled or CD38 </a:t>
                </a:r>
                <a:r>
                  <a:rPr lang="en-US" altLang="ko-KR" sz="1100" kern="100" dirty="0" err="1">
                    <a:latin typeface="Times New Roman" panose="02020603050405020304" pitchFamily="18" charset="0"/>
                  </a:rPr>
                  <a:t>shRNA</a:t>
                </a:r>
                <a:r>
                  <a:rPr lang="en-US" altLang="ko-KR" sz="1100" kern="100" dirty="0">
                    <a:latin typeface="Times New Roman" panose="02020603050405020304" pitchFamily="18" charset="0"/>
                  </a:rPr>
                  <a:t>. (C) ISO-induced </a:t>
                </a:r>
                <a:r>
                  <a:rPr lang="en-US" altLang="ko-KR" sz="1100" kern="100" dirty="0" err="1">
                    <a:latin typeface="Times New Roman" panose="02020603050405020304" pitchFamily="18" charset="0"/>
                  </a:rPr>
                  <a:t>cADPR</a:t>
                </a:r>
                <a:r>
                  <a:rPr lang="en-US" altLang="ko-KR" sz="1100" kern="100" dirty="0">
                    <a:latin typeface="Times New Roman" panose="02020603050405020304" pitchFamily="18" charset="0"/>
                  </a:rPr>
                  <a:t> production in </a:t>
                </a:r>
                <a:r>
                  <a:rPr lang="en-US" altLang="ko-KR" sz="1100" kern="100" dirty="0" err="1">
                    <a:latin typeface="Times New Roman" panose="02020603050405020304" pitchFamily="18" charset="0"/>
                  </a:rPr>
                  <a:t>cardiomyocytes</a:t>
                </a:r>
                <a:r>
                  <a:rPr lang="en-US" altLang="ko-KR" sz="1100" kern="100" dirty="0">
                    <a:latin typeface="Times New Roman" panose="02020603050405020304" pitchFamily="18" charset="0"/>
                  </a:rPr>
                  <a:t> after infection with scrambled or CD38 </a:t>
                </a:r>
                <a:r>
                  <a:rPr lang="en-US" altLang="ko-KR" sz="1100" kern="100" dirty="0" err="1">
                    <a:latin typeface="Times New Roman" panose="02020603050405020304" pitchFamily="18" charset="0"/>
                  </a:rPr>
                  <a:t>shRNA</a:t>
                </a:r>
                <a:r>
                  <a:rPr lang="en-US" altLang="ko-KR" sz="1100" kern="100" dirty="0">
                    <a:latin typeface="Times New Roman" panose="02020603050405020304" pitchFamily="18" charset="0"/>
                  </a:rPr>
                  <a:t>. *, </a:t>
                </a:r>
                <a:r>
                  <a:rPr lang="en-US" altLang="ko-KR" sz="1100" i="1" kern="100" dirty="0">
                    <a:latin typeface="Times New Roman" panose="02020603050405020304" pitchFamily="18" charset="0"/>
                    <a:ea typeface="PMingLiU" panose="02020500000000000000" pitchFamily="18" charset="-120"/>
                  </a:rPr>
                  <a:t>P</a:t>
                </a:r>
                <a:r>
                  <a:rPr lang="en-US" altLang="ko-KR" sz="1100" kern="100" dirty="0">
                    <a:latin typeface="Times New Roman" panose="02020603050405020304" pitchFamily="18" charset="0"/>
                    <a:ea typeface="PMingLiU" panose="02020500000000000000" pitchFamily="18" charset="-120"/>
                  </a:rPr>
                  <a:t>&lt; 0.01 versus scramble</a:t>
                </a:r>
                <a:r>
                  <a:rPr lang="en-US" altLang="ko-KR" sz="1100" kern="100" dirty="0">
                    <a:latin typeface="Times New Roman" panose="02020603050405020304" pitchFamily="18" charset="0"/>
                    <a:ea typeface="바탕체" panose="02030609000101010101" pitchFamily="17" charset="-127"/>
                  </a:rPr>
                  <a:t>d</a:t>
                </a:r>
                <a:r>
                  <a:rPr lang="en-US" altLang="ko-KR" sz="1100" kern="100" dirty="0">
                    <a:latin typeface="Times New Roman" panose="02020603050405020304" pitchFamily="18" charset="0"/>
                    <a:ea typeface="PMingLiU" panose="02020500000000000000" pitchFamily="18" charset="-120"/>
                  </a:rPr>
                  <a:t> </a:t>
                </a:r>
                <a:r>
                  <a:rPr lang="en-US" altLang="ko-KR" sz="1100" kern="100" dirty="0" err="1">
                    <a:latin typeface="Times New Roman" panose="02020603050405020304" pitchFamily="18" charset="0"/>
                    <a:ea typeface="PMingLiU" panose="02020500000000000000" pitchFamily="18" charset="-120"/>
                  </a:rPr>
                  <a:t>shRNA</a:t>
                </a:r>
                <a:r>
                  <a:rPr lang="en-US" altLang="ko-KR" sz="1100" kern="100" dirty="0">
                    <a:latin typeface="Times New Roman" panose="02020603050405020304" pitchFamily="18" charset="0"/>
                    <a:ea typeface="PMingLiU" panose="02020500000000000000" pitchFamily="18" charset="-120"/>
                  </a:rPr>
                  <a:t> control. #, </a:t>
                </a:r>
                <a:r>
                  <a:rPr lang="en-US" altLang="ko-KR" sz="1100" i="1" kern="100" dirty="0">
                    <a:latin typeface="Times New Roman" panose="02020603050405020304" pitchFamily="18" charset="0"/>
                    <a:ea typeface="PMingLiU" panose="02020500000000000000" pitchFamily="18" charset="-120"/>
                  </a:rPr>
                  <a:t>P</a:t>
                </a:r>
                <a:r>
                  <a:rPr lang="en-US" altLang="ko-KR" sz="1100" kern="100" dirty="0">
                    <a:latin typeface="Times New Roman" panose="02020603050405020304" pitchFamily="18" charset="0"/>
                    <a:ea typeface="PMingLiU" panose="02020500000000000000" pitchFamily="18" charset="-120"/>
                  </a:rPr>
                  <a:t> &lt; 0.01 versus scramble</a:t>
                </a:r>
                <a:r>
                  <a:rPr lang="en-US" altLang="ko-KR" sz="1100" kern="100" dirty="0">
                    <a:latin typeface="Times New Roman" panose="02020603050405020304" pitchFamily="18" charset="0"/>
                    <a:ea typeface="바탕체" panose="02030609000101010101" pitchFamily="17" charset="-127"/>
                  </a:rPr>
                  <a:t>d</a:t>
                </a:r>
                <a:r>
                  <a:rPr lang="en-US" altLang="ko-KR" sz="1100" kern="100" dirty="0">
                    <a:latin typeface="Times New Roman" panose="02020603050405020304" pitchFamily="18" charset="0"/>
                    <a:ea typeface="PMingLiU" panose="02020500000000000000" pitchFamily="18" charset="-120"/>
                  </a:rPr>
                  <a:t> </a:t>
                </a:r>
                <a:r>
                  <a:rPr lang="en-US" altLang="ko-KR" sz="1100" kern="100" dirty="0" err="1">
                    <a:latin typeface="Times New Roman" panose="02020603050405020304" pitchFamily="18" charset="0"/>
                    <a:ea typeface="PMingLiU" panose="02020500000000000000" pitchFamily="18" charset="-120"/>
                  </a:rPr>
                  <a:t>shRNA</a:t>
                </a:r>
                <a:r>
                  <a:rPr lang="en-US" altLang="ko-KR" sz="1100" kern="100" dirty="0">
                    <a:latin typeface="Times New Roman" panose="02020603050405020304" pitchFamily="18" charset="0"/>
                    <a:ea typeface="PMingLiU" panose="02020500000000000000" pitchFamily="18" charset="-120"/>
                  </a:rPr>
                  <a:t>+ ISO. </a:t>
                </a:r>
                <a:r>
                  <a:rPr lang="en-US" altLang="ko-KR" sz="1100" kern="100" dirty="0">
                    <a:latin typeface="Times New Roman" panose="02020603050405020304" pitchFamily="18" charset="0"/>
                  </a:rPr>
                  <a:t>Values are the mean ± SEM of three independent experiments</a:t>
                </a:r>
                <a:r>
                  <a:rPr lang="en-US" altLang="ko-KR" sz="1100" b="1" kern="100" dirty="0">
                    <a:latin typeface="Times New Roman" panose="02020603050405020304" pitchFamily="18" charset="0"/>
                  </a:rPr>
                  <a:t>.</a:t>
                </a:r>
                <a:endParaRPr lang="ko-KR" altLang="ko-KR" sz="1100" kern="100" dirty="0">
                  <a:effectLst/>
                  <a:latin typeface="Times New Roman" panose="02020603050405020304" pitchFamily="18" charset="0"/>
                  <a:ea typeface="바탕체" panose="02030609000101010101" pitchFamily="17" charset="-127"/>
                </a:endParaRPr>
              </a:p>
            </p:txBody>
          </p:sp>
        </p:grpSp>
        <p:graphicFrame>
          <p:nvGraphicFramePr>
            <p:cNvPr id="4" name="개체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167620950"/>
                </p:ext>
              </p:extLst>
            </p:nvPr>
          </p:nvGraphicFramePr>
          <p:xfrm>
            <a:off x="1027112" y="2082102"/>
            <a:ext cx="1000246" cy="33724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63" name="Image" r:id="rId7" imgW="414360" imgH="140040" progId="Photoshop.Image.13">
                    <p:embed/>
                  </p:oleObj>
                </mc:Choice>
                <mc:Fallback>
                  <p:oleObj name="Image" r:id="rId7" imgW="414360" imgH="140040" progId="Photoshop.Image.13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1027112" y="2082102"/>
                          <a:ext cx="1000246" cy="337248"/>
                        </a:xfrm>
                        <a:prstGeom prst="rect">
                          <a:avLst/>
                        </a:prstGeom>
                        <a:ln w="3175"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7" name="그림 6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1021285" y="2577994"/>
              <a:ext cx="1006073" cy="327058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 테마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 테마">
    <a:majorFont>
      <a:latin typeface="Calibri Ligh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 테마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 테마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 테마">
    <a:majorFont>
      <a:latin typeface="Calibri Ligh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 테마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 테마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 테마">
    <a:majorFont>
      <a:latin typeface="Calibri Ligh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 테마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96</TotalTime>
  <Words>61</Words>
  <Application>Microsoft Office PowerPoint</Application>
  <PresentationFormat>A4 용지(210x297mm)</PresentationFormat>
  <Paragraphs>25</Paragraphs>
  <Slides>1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8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11" baseType="lpstr">
      <vt:lpstr>PMingLiU</vt:lpstr>
      <vt:lpstr>굴림</vt:lpstr>
      <vt:lpstr>맑은 고딕</vt:lpstr>
      <vt:lpstr>바탕체</vt:lpstr>
      <vt:lpstr>Arial</vt:lpstr>
      <vt:lpstr>Calibri</vt:lpstr>
      <vt:lpstr>Calibri Light</vt:lpstr>
      <vt:lpstr>Times New Roman</vt:lpstr>
      <vt:lpstr>Office 테마</vt:lpstr>
      <vt:lpstr>Image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박대령</dc:creator>
  <cp:lastModifiedBy>Windows User</cp:lastModifiedBy>
  <cp:revision>225</cp:revision>
  <cp:lastPrinted>2014-07-29T08:24:50Z</cp:lastPrinted>
  <dcterms:created xsi:type="dcterms:W3CDTF">2014-05-21T07:45:37Z</dcterms:created>
  <dcterms:modified xsi:type="dcterms:W3CDTF">2016-01-30T02:33:17Z</dcterms:modified>
</cp:coreProperties>
</file>